
<file path=[Content_Types].xml><?xml version="1.0" encoding="utf-8"?>
<Types xmlns="http://schemas.openxmlformats.org/package/2006/content-types">
  <Default Extension="bin" ContentType="application/vnd.openxmlformats-officedocument.oleObject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notesSlides/notesSlide3.xml" ContentType="application/vnd.openxmlformats-officedocument.presentationml.notesSlide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71" r:id="rId2"/>
    <p:sldId id="263" r:id="rId3"/>
    <p:sldId id="270" r:id="rId4"/>
    <p:sldId id="267" r:id="rId5"/>
  </p:sldIdLst>
  <p:sldSz cx="9144000" cy="6858000" type="screen4x3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4" autoAdjust="0"/>
    <p:restoredTop sz="94662" autoAdjust="0"/>
  </p:normalViewPr>
  <p:slideViewPr>
    <p:cSldViewPr>
      <p:cViewPr>
        <p:scale>
          <a:sx n="80" d="100"/>
          <a:sy n="80" d="100"/>
        </p:scale>
        <p:origin x="390" y="-3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2.xlsx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1.bin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../embeddings/oleObject2.bin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lineChart>
        <c:grouping val="standard"/>
        <c:varyColors val="0"/>
        <c:ser>
          <c:idx val="0"/>
          <c:order val="0"/>
          <c:spPr>
            <a:ln w="15875"/>
          </c:spPr>
          <c:cat>
            <c:strRef>
              <c:f>'OAvsART-3 imag'!$V$4:$AG$4</c:f>
              <c:strCache>
                <c:ptCount val="12"/>
                <c:pt idx="1">
                  <c:v>CDT</c:v>
                </c:pt>
                <c:pt idx="2">
                  <c:v>WDT</c:v>
                </c:pt>
                <c:pt idx="3">
                  <c:v>TSL</c:v>
                </c:pt>
                <c:pt idx="4">
                  <c:v>CPT</c:v>
                </c:pt>
                <c:pt idx="5">
                  <c:v>HPT</c:v>
                </c:pt>
                <c:pt idx="6">
                  <c:v>MDT</c:v>
                </c:pt>
                <c:pt idx="7">
                  <c:v>MPT</c:v>
                </c:pt>
                <c:pt idx="8">
                  <c:v>MPS</c:v>
                </c:pt>
                <c:pt idx="9">
                  <c:v>WUR</c:v>
                </c:pt>
                <c:pt idx="10">
                  <c:v>VDT</c:v>
                </c:pt>
                <c:pt idx="11">
                  <c:v>PPT</c:v>
                </c:pt>
              </c:strCache>
            </c:strRef>
          </c:cat>
          <c:val>
            <c:numRef>
              <c:f>'OAvsART-3 imag'!$V$5:$AG$5</c:f>
              <c:numCache>
                <c:formatCode>General</c:formatCode>
                <c:ptCount val="12"/>
                <c:pt idx="1">
                  <c:v>0.63174006194962862</c:v>
                </c:pt>
                <c:pt idx="2">
                  <c:v>1.5027196885861582</c:v>
                </c:pt>
                <c:pt idx="3">
                  <c:v>0.71385557181146897</c:v>
                </c:pt>
                <c:pt idx="4">
                  <c:v>-1.2201125910297406</c:v>
                </c:pt>
                <c:pt idx="5">
                  <c:v>1.9970826143630267</c:v>
                </c:pt>
                <c:pt idx="6">
                  <c:v>1.2857947598693189</c:v>
                </c:pt>
                <c:pt idx="7">
                  <c:v>1.6626386151357697</c:v>
                </c:pt>
                <c:pt idx="8">
                  <c:v>0.49737303852092091</c:v>
                </c:pt>
                <c:pt idx="9">
                  <c:v>-0.26359438121889101</c:v>
                </c:pt>
                <c:pt idx="10">
                  <c:v>0.3281801999559637</c:v>
                </c:pt>
                <c:pt idx="11">
                  <c:v>0.42641564827440059</c:v>
                </c:pt>
              </c:numCache>
            </c:numRef>
          </c:val>
          <c:smooth val="0"/>
        </c:ser>
        <c:ser>
          <c:idx val="1"/>
          <c:order val="1"/>
          <c:spPr>
            <a:ln w="15875"/>
          </c:spPr>
          <c:cat>
            <c:strRef>
              <c:f>'OAvsART-3 imag'!$V$4:$AG$4</c:f>
              <c:strCache>
                <c:ptCount val="12"/>
                <c:pt idx="1">
                  <c:v>CDT</c:v>
                </c:pt>
                <c:pt idx="2">
                  <c:v>WDT</c:v>
                </c:pt>
                <c:pt idx="3">
                  <c:v>TSL</c:v>
                </c:pt>
                <c:pt idx="4">
                  <c:v>CPT</c:v>
                </c:pt>
                <c:pt idx="5">
                  <c:v>HPT</c:v>
                </c:pt>
                <c:pt idx="6">
                  <c:v>MDT</c:v>
                </c:pt>
                <c:pt idx="7">
                  <c:v>MPT</c:v>
                </c:pt>
                <c:pt idx="8">
                  <c:v>MPS</c:v>
                </c:pt>
                <c:pt idx="9">
                  <c:v>WUR</c:v>
                </c:pt>
                <c:pt idx="10">
                  <c:v>VDT</c:v>
                </c:pt>
                <c:pt idx="11">
                  <c:v>PPT</c:v>
                </c:pt>
              </c:strCache>
            </c:strRef>
          </c:cat>
          <c:val>
            <c:numRef>
              <c:f>'OAvsART-3 imag'!$V$6:$AG$6</c:f>
              <c:numCache>
                <c:formatCode>General</c:formatCode>
                <c:ptCount val="12"/>
                <c:pt idx="1">
                  <c:v>-0.12537059799825581</c:v>
                </c:pt>
                <c:pt idx="2">
                  <c:v>-0.3219518821336888</c:v>
                </c:pt>
                <c:pt idx="3">
                  <c:v>0.74631464278885673</c:v>
                </c:pt>
                <c:pt idx="4">
                  <c:v>-6.712644960089359E-2</c:v>
                </c:pt>
                <c:pt idx="5">
                  <c:v>-1.464812268121227</c:v>
                </c:pt>
                <c:pt idx="6">
                  <c:v>0.50631412167894863</c:v>
                </c:pt>
                <c:pt idx="7">
                  <c:v>3.1859969842655138</c:v>
                </c:pt>
                <c:pt idx="8">
                  <c:v>-0.18009126235170722</c:v>
                </c:pt>
                <c:pt idx="9">
                  <c:v>-0.6909083713577352</c:v>
                </c:pt>
                <c:pt idx="10">
                  <c:v>0.47987567005962323</c:v>
                </c:pt>
                <c:pt idx="11">
                  <c:v>3.6710952429483283</c:v>
                </c:pt>
              </c:numCache>
            </c:numRef>
          </c:val>
          <c:smooth val="0"/>
        </c:ser>
        <c:ser>
          <c:idx val="2"/>
          <c:order val="2"/>
          <c:spPr>
            <a:ln w="15875"/>
          </c:spPr>
          <c:cat>
            <c:strRef>
              <c:f>'OAvsART-3 imag'!$V$4:$AG$4</c:f>
              <c:strCache>
                <c:ptCount val="12"/>
                <c:pt idx="1">
                  <c:v>CDT</c:v>
                </c:pt>
                <c:pt idx="2">
                  <c:v>WDT</c:v>
                </c:pt>
                <c:pt idx="3">
                  <c:v>TSL</c:v>
                </c:pt>
                <c:pt idx="4">
                  <c:v>CPT</c:v>
                </c:pt>
                <c:pt idx="5">
                  <c:v>HPT</c:v>
                </c:pt>
                <c:pt idx="6">
                  <c:v>MDT</c:v>
                </c:pt>
                <c:pt idx="7">
                  <c:v>MPT</c:v>
                </c:pt>
                <c:pt idx="8">
                  <c:v>MPS</c:v>
                </c:pt>
                <c:pt idx="9">
                  <c:v>WUR</c:v>
                </c:pt>
                <c:pt idx="10">
                  <c:v>VDT</c:v>
                </c:pt>
                <c:pt idx="11">
                  <c:v>PPT</c:v>
                </c:pt>
              </c:strCache>
            </c:strRef>
          </c:cat>
          <c:val>
            <c:numRef>
              <c:f>'OAvsART-3 imag'!$V$7:$AG$7</c:f>
              <c:numCache>
                <c:formatCode>General</c:formatCode>
                <c:ptCount val="12"/>
                <c:pt idx="1">
                  <c:v>-0.49010255317747758</c:v>
                </c:pt>
                <c:pt idx="2">
                  <c:v>-0.12580209764259959</c:v>
                </c:pt>
                <c:pt idx="3">
                  <c:v>2.0646319272428579</c:v>
                </c:pt>
                <c:pt idx="4">
                  <c:v>-0.79279117364142204</c:v>
                </c:pt>
                <c:pt idx="5">
                  <c:v>1.2993102281174174</c:v>
                </c:pt>
                <c:pt idx="6">
                  <c:v>1.2857947598693189</c:v>
                </c:pt>
                <c:pt idx="7">
                  <c:v>2.4241868744390143</c:v>
                </c:pt>
                <c:pt idx="8">
                  <c:v>-1.1778481403675385</c:v>
                </c:pt>
                <c:pt idx="9">
                  <c:v>-0.64958157823267348</c:v>
                </c:pt>
                <c:pt idx="10">
                  <c:v>0.3281801999559637</c:v>
                </c:pt>
                <c:pt idx="11">
                  <c:v>4.3023733457103495</c:v>
                </c:pt>
              </c:numCache>
            </c:numRef>
          </c:val>
          <c:smooth val="0"/>
        </c:ser>
        <c:ser>
          <c:idx val="3"/>
          <c:order val="3"/>
          <c:spPr>
            <a:ln w="15875"/>
          </c:spPr>
          <c:cat>
            <c:strRef>
              <c:f>'OAvsART-3 imag'!$V$4:$AG$4</c:f>
              <c:strCache>
                <c:ptCount val="12"/>
                <c:pt idx="1">
                  <c:v>CDT</c:v>
                </c:pt>
                <c:pt idx="2">
                  <c:v>WDT</c:v>
                </c:pt>
                <c:pt idx="3">
                  <c:v>TSL</c:v>
                </c:pt>
                <c:pt idx="4">
                  <c:v>CPT</c:v>
                </c:pt>
                <c:pt idx="5">
                  <c:v>HPT</c:v>
                </c:pt>
                <c:pt idx="6">
                  <c:v>MDT</c:v>
                </c:pt>
                <c:pt idx="7">
                  <c:v>MPT</c:v>
                </c:pt>
                <c:pt idx="8">
                  <c:v>MPS</c:v>
                </c:pt>
                <c:pt idx="9">
                  <c:v>WUR</c:v>
                </c:pt>
                <c:pt idx="10">
                  <c:v>VDT</c:v>
                </c:pt>
                <c:pt idx="11">
                  <c:v>PPT</c:v>
                </c:pt>
              </c:strCache>
            </c:strRef>
          </c:cat>
          <c:val>
            <c:numRef>
              <c:f>'OAvsART-3 imag'!$V$8:$AG$8</c:f>
              <c:numCache>
                <c:formatCode>General</c:formatCode>
                <c:ptCount val="12"/>
                <c:pt idx="1">
                  <c:v>0.75057475504440463</c:v>
                </c:pt>
                <c:pt idx="2">
                  <c:v>0.45572882558505534</c:v>
                </c:pt>
                <c:pt idx="3">
                  <c:v>0.4987267298281633</c:v>
                </c:pt>
                <c:pt idx="4">
                  <c:v>2.3000778656264673</c:v>
                </c:pt>
                <c:pt idx="5">
                  <c:v>3.3892565057612725</c:v>
                </c:pt>
                <c:pt idx="6">
                  <c:v>1.2857947598693189</c:v>
                </c:pt>
                <c:pt idx="7">
                  <c:v>4.1373590263403743</c:v>
                </c:pt>
                <c:pt idx="8">
                  <c:v>-1.213164162590294</c:v>
                </c:pt>
                <c:pt idx="9">
                  <c:v>0.61251014042980467</c:v>
                </c:pt>
                <c:pt idx="10">
                  <c:v>-6.6228022313552251E-2</c:v>
                </c:pt>
                <c:pt idx="11">
                  <c:v>5.3519206770711385</c:v>
                </c:pt>
              </c:numCache>
            </c:numRef>
          </c:val>
          <c:smooth val="0"/>
        </c:ser>
        <c:ser>
          <c:idx val="4"/>
          <c:order val="4"/>
          <c:spPr>
            <a:ln w="15875"/>
          </c:spPr>
          <c:cat>
            <c:strRef>
              <c:f>'OAvsART-3 imag'!$V$4:$AG$4</c:f>
              <c:strCache>
                <c:ptCount val="12"/>
                <c:pt idx="1">
                  <c:v>CDT</c:v>
                </c:pt>
                <c:pt idx="2">
                  <c:v>WDT</c:v>
                </c:pt>
                <c:pt idx="3">
                  <c:v>TSL</c:v>
                </c:pt>
                <c:pt idx="4">
                  <c:v>CPT</c:v>
                </c:pt>
                <c:pt idx="5">
                  <c:v>HPT</c:v>
                </c:pt>
                <c:pt idx="6">
                  <c:v>MDT</c:v>
                </c:pt>
                <c:pt idx="7">
                  <c:v>MPT</c:v>
                </c:pt>
                <c:pt idx="8">
                  <c:v>MPS</c:v>
                </c:pt>
                <c:pt idx="9">
                  <c:v>WUR</c:v>
                </c:pt>
                <c:pt idx="10">
                  <c:v>VDT</c:v>
                </c:pt>
                <c:pt idx="11">
                  <c:v>PPT</c:v>
                </c:pt>
              </c:strCache>
            </c:strRef>
          </c:cat>
          <c:val>
            <c:numRef>
              <c:f>'OAvsART-3 imag'!$V$9:$AG$9</c:f>
              <c:numCache>
                <c:formatCode>General</c:formatCode>
                <c:ptCount val="12"/>
                <c:pt idx="1">
                  <c:v>-0.43540901926368869</c:v>
                </c:pt>
                <c:pt idx="2">
                  <c:v>-2.3980903144218111</c:v>
                </c:pt>
                <c:pt idx="3">
                  <c:v>0.60375502260855074</c:v>
                </c:pt>
                <c:pt idx="4">
                  <c:v>1.2747670257343744</c:v>
                </c:pt>
                <c:pt idx="5">
                  <c:v>1.2116673197000951</c:v>
                </c:pt>
                <c:pt idx="6">
                  <c:v>1.2857947598693189</c:v>
                </c:pt>
                <c:pt idx="7">
                  <c:v>2.1387915877332562</c:v>
                </c:pt>
                <c:pt idx="8">
                  <c:v>1.2499623097981467</c:v>
                </c:pt>
                <c:pt idx="9">
                  <c:v>2.336901925997882</c:v>
                </c:pt>
                <c:pt idx="10">
                  <c:v>-0.27860168045867728</c:v>
                </c:pt>
                <c:pt idx="11">
                  <c:v>3.273469393022121</c:v>
                </c:pt>
              </c:numCache>
            </c:numRef>
          </c:val>
          <c:smooth val="0"/>
        </c:ser>
        <c:ser>
          <c:idx val="5"/>
          <c:order val="5"/>
          <c:spPr>
            <a:ln w="15875"/>
          </c:spPr>
          <c:cat>
            <c:strRef>
              <c:f>'OAvsART-3 imag'!$V$4:$AG$4</c:f>
              <c:strCache>
                <c:ptCount val="12"/>
                <c:pt idx="1">
                  <c:v>CDT</c:v>
                </c:pt>
                <c:pt idx="2">
                  <c:v>WDT</c:v>
                </c:pt>
                <c:pt idx="3">
                  <c:v>TSL</c:v>
                </c:pt>
                <c:pt idx="4">
                  <c:v>CPT</c:v>
                </c:pt>
                <c:pt idx="5">
                  <c:v>HPT</c:v>
                </c:pt>
                <c:pt idx="6">
                  <c:v>MDT</c:v>
                </c:pt>
                <c:pt idx="7">
                  <c:v>MPT</c:v>
                </c:pt>
                <c:pt idx="8">
                  <c:v>MPS</c:v>
                </c:pt>
                <c:pt idx="9">
                  <c:v>WUR</c:v>
                </c:pt>
                <c:pt idx="10">
                  <c:v>VDT</c:v>
                </c:pt>
                <c:pt idx="11">
                  <c:v>PPT</c:v>
                </c:pt>
              </c:strCache>
            </c:strRef>
          </c:cat>
          <c:val>
            <c:numRef>
              <c:f>'OAvsART-3 imag'!$V$10:$AG$10</c:f>
              <c:numCache>
                <c:formatCode>General</c:formatCode>
                <c:ptCount val="12"/>
                <c:pt idx="1">
                  <c:v>0.30170935726731696</c:v>
                </c:pt>
                <c:pt idx="2">
                  <c:v>-1.1695245279229749</c:v>
                </c:pt>
                <c:pt idx="3">
                  <c:v>-1.0633915144972765</c:v>
                </c:pt>
                <c:pt idx="4">
                  <c:v>1.8571227378458939</c:v>
                </c:pt>
                <c:pt idx="5">
                  <c:v>2.4117009887988248</c:v>
                </c:pt>
                <c:pt idx="6">
                  <c:v>-3.4733954827997291</c:v>
                </c:pt>
                <c:pt idx="7">
                  <c:v>3.3761993847843992</c:v>
                </c:pt>
                <c:pt idx="8">
                  <c:v>-1.0771846522064854</c:v>
                </c:pt>
                <c:pt idx="9">
                  <c:v>0.4309396334499922</c:v>
                </c:pt>
                <c:pt idx="10">
                  <c:v>-0.17241485138611476</c:v>
                </c:pt>
                <c:pt idx="11">
                  <c:v>3.1655982497759596</c:v>
                </c:pt>
              </c:numCache>
            </c:numRef>
          </c:val>
          <c:smooth val="0"/>
        </c:ser>
        <c:ser>
          <c:idx val="6"/>
          <c:order val="6"/>
          <c:spPr>
            <a:ln w="15875">
              <a:solidFill>
                <a:sysClr val="windowText" lastClr="000000">
                  <a:lumMod val="65000"/>
                  <a:lumOff val="35000"/>
                </a:sysClr>
              </a:solidFill>
            </a:ln>
          </c:spPr>
          <c:marker>
            <c:spPr>
              <a:solidFill>
                <a:sysClr val="windowText" lastClr="000000">
                  <a:lumMod val="65000"/>
                  <a:lumOff val="35000"/>
                </a:sysClr>
              </a:solidFill>
              <a:ln>
                <a:solidFill>
                  <a:sysClr val="windowText" lastClr="000000">
                    <a:lumMod val="65000"/>
                    <a:lumOff val="35000"/>
                  </a:sysClr>
                </a:solidFill>
              </a:ln>
            </c:spPr>
          </c:marker>
          <c:cat>
            <c:strRef>
              <c:f>'OAvsART-3 imag'!$V$4:$AG$4</c:f>
              <c:strCache>
                <c:ptCount val="12"/>
                <c:pt idx="1">
                  <c:v>CDT</c:v>
                </c:pt>
                <c:pt idx="2">
                  <c:v>WDT</c:v>
                </c:pt>
                <c:pt idx="3">
                  <c:v>TSL</c:v>
                </c:pt>
                <c:pt idx="4">
                  <c:v>CPT</c:v>
                </c:pt>
                <c:pt idx="5">
                  <c:v>HPT</c:v>
                </c:pt>
                <c:pt idx="6">
                  <c:v>MDT</c:v>
                </c:pt>
                <c:pt idx="7">
                  <c:v>MPT</c:v>
                </c:pt>
                <c:pt idx="8">
                  <c:v>MPS</c:v>
                </c:pt>
                <c:pt idx="9">
                  <c:v>WUR</c:v>
                </c:pt>
                <c:pt idx="10">
                  <c:v>VDT</c:v>
                </c:pt>
                <c:pt idx="11">
                  <c:v>PPT</c:v>
                </c:pt>
              </c:strCache>
            </c:strRef>
          </c:cat>
          <c:val>
            <c:numRef>
              <c:f>'OAvsART-3 imag'!$V$11:$AG$11</c:f>
              <c:numCache>
                <c:formatCode>General</c:formatCode>
                <c:ptCount val="12"/>
                <c:pt idx="1">
                  <c:v>0.82453264725943531</c:v>
                </c:pt>
                <c:pt idx="2">
                  <c:v>0.54303103811837949</c:v>
                </c:pt>
                <c:pt idx="3">
                  <c:v>0.73815645436745014</c:v>
                </c:pt>
                <c:pt idx="4">
                  <c:v>1.7659260938910695</c:v>
                </c:pt>
                <c:pt idx="5">
                  <c:v>2.5937285678194186</c:v>
                </c:pt>
                <c:pt idx="6">
                  <c:v>-1.4832079064880299</c:v>
                </c:pt>
                <c:pt idx="7">
                  <c:v>-0.43180395205824063</c:v>
                </c:pt>
                <c:pt idx="8">
                  <c:v>0.80527777421452629</c:v>
                </c:pt>
                <c:pt idx="9">
                  <c:v>0.57432661599400403</c:v>
                </c:pt>
                <c:pt idx="10">
                  <c:v>8.5467447790107301E-2</c:v>
                </c:pt>
                <c:pt idx="11">
                  <c:v>-0.35638021078512194</c:v>
                </c:pt>
              </c:numCache>
            </c:numRef>
          </c:val>
          <c:smooth val="0"/>
        </c:ser>
        <c:ser>
          <c:idx val="7"/>
          <c:order val="7"/>
          <c:spPr>
            <a:ln w="15875">
              <a:solidFill>
                <a:sysClr val="windowText" lastClr="000000"/>
              </a:solidFill>
            </a:ln>
          </c:spPr>
          <c:marker>
            <c:symbol val="circle"/>
            <c:size val="5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</c:spPr>
          </c:marker>
          <c:cat>
            <c:strRef>
              <c:f>'OAvsART-3 imag'!$V$4:$AG$4</c:f>
              <c:strCache>
                <c:ptCount val="12"/>
                <c:pt idx="1">
                  <c:v>CDT</c:v>
                </c:pt>
                <c:pt idx="2">
                  <c:v>WDT</c:v>
                </c:pt>
                <c:pt idx="3">
                  <c:v>TSL</c:v>
                </c:pt>
                <c:pt idx="4">
                  <c:v>CPT</c:v>
                </c:pt>
                <c:pt idx="5">
                  <c:v>HPT</c:v>
                </c:pt>
                <c:pt idx="6">
                  <c:v>MDT</c:v>
                </c:pt>
                <c:pt idx="7">
                  <c:v>MPT</c:v>
                </c:pt>
                <c:pt idx="8">
                  <c:v>MPS</c:v>
                </c:pt>
                <c:pt idx="9">
                  <c:v>WUR</c:v>
                </c:pt>
                <c:pt idx="10">
                  <c:v>VDT</c:v>
                </c:pt>
                <c:pt idx="11">
                  <c:v>PPT</c:v>
                </c:pt>
              </c:strCache>
            </c:strRef>
          </c:cat>
          <c:val>
            <c:numRef>
              <c:f>'OAvsART-3 imag'!$V$12:$AG$12</c:f>
              <c:numCache>
                <c:formatCode>General</c:formatCode>
                <c:ptCount val="12"/>
                <c:pt idx="1">
                  <c:v>0.971731473764467</c:v>
                </c:pt>
                <c:pt idx="2">
                  <c:v>-7.6621559824744556E-2</c:v>
                </c:pt>
                <c:pt idx="3">
                  <c:v>-0.41847568181196781</c:v>
                </c:pt>
                <c:pt idx="4">
                  <c:v>1.8831789218329864</c:v>
                </c:pt>
                <c:pt idx="5">
                  <c:v>1.6937033159953709</c:v>
                </c:pt>
                <c:pt idx="6">
                  <c:v>-8.8068850984698077</c:v>
                </c:pt>
                <c:pt idx="7">
                  <c:v>0.32979680727884236</c:v>
                </c:pt>
                <c:pt idx="8">
                  <c:v>-1.1824734477374148</c:v>
                </c:pt>
                <c:pt idx="9">
                  <c:v>-2.6544418823359971E-2</c:v>
                </c:pt>
                <c:pt idx="10">
                  <c:v>-1.6893695524227157</c:v>
                </c:pt>
                <c:pt idx="11">
                  <c:v>1.2152828047835063</c:v>
                </c:pt>
              </c:numCache>
            </c:numRef>
          </c:val>
          <c:smooth val="0"/>
        </c:ser>
        <c:ser>
          <c:idx val="8"/>
          <c:order val="8"/>
          <c:spPr>
            <a:ln w="15875"/>
          </c:spPr>
          <c:cat>
            <c:strRef>
              <c:f>'OAvsART-3 imag'!$V$4:$AG$4</c:f>
              <c:strCache>
                <c:ptCount val="12"/>
                <c:pt idx="1">
                  <c:v>CDT</c:v>
                </c:pt>
                <c:pt idx="2">
                  <c:v>WDT</c:v>
                </c:pt>
                <c:pt idx="3">
                  <c:v>TSL</c:v>
                </c:pt>
                <c:pt idx="4">
                  <c:v>CPT</c:v>
                </c:pt>
                <c:pt idx="5">
                  <c:v>HPT</c:v>
                </c:pt>
                <c:pt idx="6">
                  <c:v>MDT</c:v>
                </c:pt>
                <c:pt idx="7">
                  <c:v>MPT</c:v>
                </c:pt>
                <c:pt idx="8">
                  <c:v>MPS</c:v>
                </c:pt>
                <c:pt idx="9">
                  <c:v>WUR</c:v>
                </c:pt>
                <c:pt idx="10">
                  <c:v>VDT</c:v>
                </c:pt>
                <c:pt idx="11">
                  <c:v>PPT</c:v>
                </c:pt>
              </c:strCache>
            </c:strRef>
          </c:cat>
          <c:val>
            <c:numRef>
              <c:f>'OAvsART-3 imag'!$V$13:$AG$13</c:f>
              <c:numCache>
                <c:formatCode>General</c:formatCode>
                <c:ptCount val="12"/>
                <c:pt idx="1">
                  <c:v>-4.8516307576806299E-2</c:v>
                </c:pt>
                <c:pt idx="2">
                  <c:v>0.36860722955066449</c:v>
                </c:pt>
                <c:pt idx="3">
                  <c:v>-0.69954319930197917</c:v>
                </c:pt>
                <c:pt idx="4">
                  <c:v>-0.41888493342664362</c:v>
                </c:pt>
                <c:pt idx="5">
                  <c:v>-1.633356322769925</c:v>
                </c:pt>
                <c:pt idx="6">
                  <c:v>1.1818539982645202</c:v>
                </c:pt>
                <c:pt idx="7">
                  <c:v>-1.2886051406507126</c:v>
                </c:pt>
                <c:pt idx="8">
                  <c:v>-0.76570198247580956</c:v>
                </c:pt>
                <c:pt idx="9">
                  <c:v>1.2438212033170974</c:v>
                </c:pt>
                <c:pt idx="10">
                  <c:v>-0.67300990272819317</c:v>
                </c:pt>
                <c:pt idx="11">
                  <c:v>4.039930962932932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02399456"/>
        <c:axId val="502407616"/>
      </c:lineChart>
      <c:catAx>
        <c:axId val="50239945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9050">
            <a:solidFill>
              <a:sysClr val="windowText" lastClr="000000"/>
            </a:solidFill>
          </a:ln>
        </c:spPr>
        <c:crossAx val="502407616"/>
        <c:crossesAt val="-10"/>
        <c:auto val="1"/>
        <c:lblAlgn val="ctr"/>
        <c:lblOffset val="100"/>
        <c:noMultiLvlLbl val="0"/>
      </c:catAx>
      <c:valAx>
        <c:axId val="502407616"/>
        <c:scaling>
          <c:orientation val="minMax"/>
          <c:max val="10"/>
          <c:min val="-1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ysClr val="windowText" lastClr="000000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502399456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b="1"/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lineChart>
        <c:grouping val="standard"/>
        <c:varyColors val="0"/>
        <c:ser>
          <c:idx val="0"/>
          <c:order val="0"/>
          <c:spPr>
            <a:ln w="15875"/>
          </c:spPr>
          <c:cat>
            <c:strRef>
              <c:f>'OAvsART-3 imag'!$C$4:$N$4</c:f>
              <c:strCache>
                <c:ptCount val="12"/>
                <c:pt idx="1">
                  <c:v>CDT</c:v>
                </c:pt>
                <c:pt idx="2">
                  <c:v>WDT</c:v>
                </c:pt>
                <c:pt idx="3">
                  <c:v>TSL</c:v>
                </c:pt>
                <c:pt idx="4">
                  <c:v>CPT</c:v>
                </c:pt>
                <c:pt idx="5">
                  <c:v>HPT</c:v>
                </c:pt>
                <c:pt idx="6">
                  <c:v>MDT</c:v>
                </c:pt>
                <c:pt idx="7">
                  <c:v>MPT</c:v>
                </c:pt>
                <c:pt idx="8">
                  <c:v>MPS</c:v>
                </c:pt>
                <c:pt idx="9">
                  <c:v>WUR</c:v>
                </c:pt>
                <c:pt idx="10">
                  <c:v>VDT</c:v>
                </c:pt>
                <c:pt idx="11">
                  <c:v>PPT</c:v>
                </c:pt>
              </c:strCache>
            </c:strRef>
          </c:cat>
          <c:val>
            <c:numRef>
              <c:f>'OAvsART-3 imag'!$C$5:$N$5</c:f>
              <c:numCache>
                <c:formatCode>General</c:formatCode>
                <c:ptCount val="12"/>
                <c:pt idx="1">
                  <c:v>-3.1684080505600818</c:v>
                </c:pt>
                <c:pt idx="2">
                  <c:v>-1.6107293954438091</c:v>
                </c:pt>
                <c:pt idx="3">
                  <c:v>-2.3859435934921658</c:v>
                </c:pt>
                <c:pt idx="4">
                  <c:v>0.36670901378419796</c:v>
                </c:pt>
                <c:pt idx="5">
                  <c:v>-0.58838318394799982</c:v>
                </c:pt>
                <c:pt idx="6">
                  <c:v>1.2857947598693189</c:v>
                </c:pt>
                <c:pt idx="7">
                  <c:v>3.4713322720184467</c:v>
                </c:pt>
                <c:pt idx="8">
                  <c:v>-0.86812739287708751</c:v>
                </c:pt>
                <c:pt idx="9">
                  <c:v>0.14019722369837109</c:v>
                </c:pt>
                <c:pt idx="10">
                  <c:v>0.47987567005962323</c:v>
                </c:pt>
                <c:pt idx="11">
                  <c:v>3.383792361893402</c:v>
                </c:pt>
              </c:numCache>
            </c:numRef>
          </c:val>
          <c:smooth val="0"/>
        </c:ser>
        <c:ser>
          <c:idx val="1"/>
          <c:order val="1"/>
          <c:spPr>
            <a:ln w="15875">
              <a:solidFill>
                <a:sysClr val="windowText" lastClr="000000">
                  <a:lumMod val="65000"/>
                  <a:lumOff val="35000"/>
                </a:sysClr>
              </a:solidFill>
            </a:ln>
          </c:spPr>
          <c:marker>
            <c:spPr>
              <a:solidFill>
                <a:sysClr val="windowText" lastClr="000000">
                  <a:lumMod val="65000"/>
                  <a:lumOff val="35000"/>
                </a:sysClr>
              </a:solidFill>
              <a:ln>
                <a:solidFill>
                  <a:sysClr val="windowText" lastClr="000000">
                    <a:lumMod val="65000"/>
                    <a:lumOff val="35000"/>
                  </a:sysClr>
                </a:solidFill>
              </a:ln>
            </c:spPr>
          </c:marker>
          <c:cat>
            <c:strRef>
              <c:f>'OAvsART-3 imag'!$C$4:$N$4</c:f>
              <c:strCache>
                <c:ptCount val="12"/>
                <c:pt idx="1">
                  <c:v>CDT</c:v>
                </c:pt>
                <c:pt idx="2">
                  <c:v>WDT</c:v>
                </c:pt>
                <c:pt idx="3">
                  <c:v>TSL</c:v>
                </c:pt>
                <c:pt idx="4">
                  <c:v>CPT</c:v>
                </c:pt>
                <c:pt idx="5">
                  <c:v>HPT</c:v>
                </c:pt>
                <c:pt idx="6">
                  <c:v>MDT</c:v>
                </c:pt>
                <c:pt idx="7">
                  <c:v>MPT</c:v>
                </c:pt>
                <c:pt idx="8">
                  <c:v>MPS</c:v>
                </c:pt>
                <c:pt idx="9">
                  <c:v>WUR</c:v>
                </c:pt>
                <c:pt idx="10">
                  <c:v>VDT</c:v>
                </c:pt>
                <c:pt idx="11">
                  <c:v>PPT</c:v>
                </c:pt>
              </c:strCache>
            </c:strRef>
          </c:cat>
          <c:val>
            <c:numRef>
              <c:f>'OAvsART-3 imag'!$C$6:$N$6</c:f>
              <c:numCache>
                <c:formatCode>General</c:formatCode>
                <c:ptCount val="12"/>
                <c:pt idx="1">
                  <c:v>-1.9686608381768629</c:v>
                </c:pt>
                <c:pt idx="2">
                  <c:v>-4.6644876772278723</c:v>
                </c:pt>
                <c:pt idx="3">
                  <c:v>-1.9393809065995515</c:v>
                </c:pt>
                <c:pt idx="4">
                  <c:v>0.56734163048481068</c:v>
                </c:pt>
                <c:pt idx="5">
                  <c:v>-0.42995177257822176</c:v>
                </c:pt>
                <c:pt idx="6">
                  <c:v>-5.3431912640974391</c:v>
                </c:pt>
                <c:pt idx="7">
                  <c:v>-0.52697721670428554</c:v>
                </c:pt>
                <c:pt idx="8">
                  <c:v>-0.56836672151743695</c:v>
                </c:pt>
                <c:pt idx="9">
                  <c:v>1.0243890026063771</c:v>
                </c:pt>
                <c:pt idx="10">
                  <c:v>0.13097608882120571</c:v>
                </c:pt>
                <c:pt idx="11">
                  <c:v>-0.82370810728310362</c:v>
                </c:pt>
              </c:numCache>
            </c:numRef>
          </c:val>
          <c:smooth val="0"/>
        </c:ser>
        <c:ser>
          <c:idx val="2"/>
          <c:order val="2"/>
          <c:spPr>
            <a:ln w="15875">
              <a:solidFill>
                <a:sysClr val="windowText" lastClr="000000">
                  <a:lumMod val="65000"/>
                  <a:lumOff val="35000"/>
                </a:sysClr>
              </a:solidFill>
            </a:ln>
          </c:spPr>
          <c:marker>
            <c:symbol val="dot"/>
            <c:size val="5"/>
            <c:spPr>
              <a:solidFill>
                <a:sysClr val="windowText" lastClr="000000">
                  <a:lumMod val="65000"/>
                  <a:lumOff val="35000"/>
                </a:sysClr>
              </a:solidFill>
              <a:ln>
                <a:solidFill>
                  <a:sysClr val="windowText" lastClr="000000">
                    <a:lumMod val="65000"/>
                    <a:lumOff val="35000"/>
                  </a:sysClr>
                </a:solidFill>
              </a:ln>
            </c:spPr>
          </c:marker>
          <c:cat>
            <c:strRef>
              <c:f>'OAvsART-3 imag'!$C$4:$N$4</c:f>
              <c:strCache>
                <c:ptCount val="12"/>
                <c:pt idx="1">
                  <c:v>CDT</c:v>
                </c:pt>
                <c:pt idx="2">
                  <c:v>WDT</c:v>
                </c:pt>
                <c:pt idx="3">
                  <c:v>TSL</c:v>
                </c:pt>
                <c:pt idx="4">
                  <c:v>CPT</c:v>
                </c:pt>
                <c:pt idx="5">
                  <c:v>HPT</c:v>
                </c:pt>
                <c:pt idx="6">
                  <c:v>MDT</c:v>
                </c:pt>
                <c:pt idx="7">
                  <c:v>MPT</c:v>
                </c:pt>
                <c:pt idx="8">
                  <c:v>MPS</c:v>
                </c:pt>
                <c:pt idx="9">
                  <c:v>WUR</c:v>
                </c:pt>
                <c:pt idx="10">
                  <c:v>VDT</c:v>
                </c:pt>
                <c:pt idx="11">
                  <c:v>PPT</c:v>
                </c:pt>
              </c:strCache>
            </c:strRef>
          </c:cat>
          <c:val>
            <c:numRef>
              <c:f>'OAvsART-3 imag'!$C$7:$N$7</c:f>
              <c:numCache>
                <c:formatCode>General</c:formatCode>
                <c:ptCount val="12"/>
                <c:pt idx="1">
                  <c:v>0.57955417552751376</c:v>
                </c:pt>
                <c:pt idx="2">
                  <c:v>0.29407476634163465</c:v>
                </c:pt>
                <c:pt idx="3">
                  <c:v>0.46235895362530766</c:v>
                </c:pt>
                <c:pt idx="4">
                  <c:v>1.8571227378458939</c:v>
                </c:pt>
                <c:pt idx="5">
                  <c:v>-0.38613031836956185</c:v>
                </c:pt>
                <c:pt idx="6">
                  <c:v>-0.29675498174027326</c:v>
                </c:pt>
                <c:pt idx="7">
                  <c:v>-1.6694102092119454</c:v>
                </c:pt>
                <c:pt idx="8">
                  <c:v>2.2048171357213135</c:v>
                </c:pt>
                <c:pt idx="9">
                  <c:v>4.3231900276354889</c:v>
                </c:pt>
                <c:pt idx="10">
                  <c:v>0.84394479830840785</c:v>
                </c:pt>
                <c:pt idx="11">
                  <c:v>-0.38213094321058744</c:v>
                </c:pt>
              </c:numCache>
            </c:numRef>
          </c:val>
          <c:smooth val="0"/>
        </c:ser>
        <c:ser>
          <c:idx val="3"/>
          <c:order val="3"/>
          <c:spPr>
            <a:ln w="15875"/>
          </c:spPr>
          <c:cat>
            <c:strRef>
              <c:f>'OAvsART-3 imag'!$C$4:$N$4</c:f>
              <c:strCache>
                <c:ptCount val="12"/>
                <c:pt idx="1">
                  <c:v>CDT</c:v>
                </c:pt>
                <c:pt idx="2">
                  <c:v>WDT</c:v>
                </c:pt>
                <c:pt idx="3">
                  <c:v>TSL</c:v>
                </c:pt>
                <c:pt idx="4">
                  <c:v>CPT</c:v>
                </c:pt>
                <c:pt idx="5">
                  <c:v>HPT</c:v>
                </c:pt>
                <c:pt idx="6">
                  <c:v>MDT</c:v>
                </c:pt>
                <c:pt idx="7">
                  <c:v>MPT</c:v>
                </c:pt>
                <c:pt idx="8">
                  <c:v>MPS</c:v>
                </c:pt>
                <c:pt idx="9">
                  <c:v>WUR</c:v>
                </c:pt>
                <c:pt idx="10">
                  <c:v>VDT</c:v>
                </c:pt>
                <c:pt idx="11">
                  <c:v>PPT</c:v>
                </c:pt>
              </c:strCache>
            </c:strRef>
          </c:cat>
          <c:val>
            <c:numRef>
              <c:f>'OAvsART-3 imag'!$C$8:$N$8</c:f>
              <c:numCache>
                <c:formatCode>General</c:formatCode>
                <c:ptCount val="12"/>
                <c:pt idx="1">
                  <c:v>0.70608441019781287</c:v>
                </c:pt>
                <c:pt idx="2">
                  <c:v>-1.7646564048337599</c:v>
                </c:pt>
                <c:pt idx="3">
                  <c:v>-3.221885689011728</c:v>
                </c:pt>
                <c:pt idx="4">
                  <c:v>-1.4051114973380976</c:v>
                </c:pt>
                <c:pt idx="5">
                  <c:v>-0.20410273934896839</c:v>
                </c:pt>
                <c:pt idx="6">
                  <c:v>1.1818539982645202</c:v>
                </c:pt>
                <c:pt idx="7">
                  <c:v>4.4194978991127946E-2</c:v>
                </c:pt>
                <c:pt idx="8">
                  <c:v>1.6268446796603993</c:v>
                </c:pt>
                <c:pt idx="9">
                  <c:v>0.54328202912156787</c:v>
                </c:pt>
                <c:pt idx="10">
                  <c:v>-0.67300990272819317</c:v>
                </c:pt>
                <c:pt idx="11">
                  <c:v>1.9457175931636805</c:v>
                </c:pt>
              </c:numCache>
            </c:numRef>
          </c:val>
          <c:smooth val="0"/>
        </c:ser>
        <c:ser>
          <c:idx val="4"/>
          <c:order val="4"/>
          <c:spPr>
            <a:ln w="15875"/>
          </c:spPr>
          <c:cat>
            <c:strRef>
              <c:f>'OAvsART-3 imag'!$C$4:$N$4</c:f>
              <c:strCache>
                <c:ptCount val="12"/>
                <c:pt idx="1">
                  <c:v>CDT</c:v>
                </c:pt>
                <c:pt idx="2">
                  <c:v>WDT</c:v>
                </c:pt>
                <c:pt idx="3">
                  <c:v>TSL</c:v>
                </c:pt>
                <c:pt idx="4">
                  <c:v>CPT</c:v>
                </c:pt>
                <c:pt idx="5">
                  <c:v>HPT</c:v>
                </c:pt>
                <c:pt idx="6">
                  <c:v>MDT</c:v>
                </c:pt>
                <c:pt idx="7">
                  <c:v>MPT</c:v>
                </c:pt>
                <c:pt idx="8">
                  <c:v>MPS</c:v>
                </c:pt>
                <c:pt idx="9">
                  <c:v>WUR</c:v>
                </c:pt>
                <c:pt idx="10">
                  <c:v>VDT</c:v>
                </c:pt>
                <c:pt idx="11">
                  <c:v>PPT</c:v>
                </c:pt>
              </c:strCache>
            </c:strRef>
          </c:cat>
          <c:val>
            <c:numRef>
              <c:f>'OAvsART-3 imag'!$C$9:$N$9</c:f>
              <c:numCache>
                <c:formatCode>General</c:formatCode>
                <c:ptCount val="12"/>
                <c:pt idx="1">
                  <c:v>-0.25662133514141455</c:v>
                </c:pt>
                <c:pt idx="2">
                  <c:v>-0.85669977542864195</c:v>
                </c:pt>
                <c:pt idx="3">
                  <c:v>-0.75943962106406671</c:v>
                </c:pt>
                <c:pt idx="4">
                  <c:v>1.3359990581040422</c:v>
                </c:pt>
                <c:pt idx="5">
                  <c:v>1.0296397406795017</c:v>
                </c:pt>
                <c:pt idx="6">
                  <c:v>0.24072896564003257</c:v>
                </c:pt>
                <c:pt idx="7">
                  <c:v>2.5193197616730623</c:v>
                </c:pt>
                <c:pt idx="8">
                  <c:v>-1.9114469142457511</c:v>
                </c:pt>
                <c:pt idx="9">
                  <c:v>-0.44170571306828355</c:v>
                </c:pt>
                <c:pt idx="10">
                  <c:v>1.3445398496504863</c:v>
                </c:pt>
                <c:pt idx="11">
                  <c:v>0.97166170064009905</c:v>
                </c:pt>
              </c:numCache>
            </c:numRef>
          </c:val>
          <c:smooth val="0"/>
        </c:ser>
        <c:ser>
          <c:idx val="5"/>
          <c:order val="5"/>
          <c:spPr>
            <a:ln w="15875"/>
          </c:spPr>
          <c:cat>
            <c:strRef>
              <c:f>'OAvsART-3 imag'!$C$4:$N$4</c:f>
              <c:strCache>
                <c:ptCount val="12"/>
                <c:pt idx="1">
                  <c:v>CDT</c:v>
                </c:pt>
                <c:pt idx="2">
                  <c:v>WDT</c:v>
                </c:pt>
                <c:pt idx="3">
                  <c:v>TSL</c:v>
                </c:pt>
                <c:pt idx="4">
                  <c:v>CPT</c:v>
                </c:pt>
                <c:pt idx="5">
                  <c:v>HPT</c:v>
                </c:pt>
                <c:pt idx="6">
                  <c:v>MDT</c:v>
                </c:pt>
                <c:pt idx="7">
                  <c:v>MPT</c:v>
                </c:pt>
                <c:pt idx="8">
                  <c:v>MPS</c:v>
                </c:pt>
                <c:pt idx="9">
                  <c:v>WUR</c:v>
                </c:pt>
                <c:pt idx="10">
                  <c:v>VDT</c:v>
                </c:pt>
                <c:pt idx="11">
                  <c:v>PPT</c:v>
                </c:pt>
              </c:strCache>
            </c:strRef>
          </c:cat>
          <c:val>
            <c:numRef>
              <c:f>'OAvsART-3 imag'!$C$10:$N$10</c:f>
              <c:numCache>
                <c:formatCode>General</c:formatCode>
                <c:ptCount val="12"/>
                <c:pt idx="1">
                  <c:v>-0.2798619897384243</c:v>
                </c:pt>
                <c:pt idx="2">
                  <c:v>-0.61447402432735576</c:v>
                </c:pt>
                <c:pt idx="3">
                  <c:v>-0.77207240258055598</c:v>
                </c:pt>
                <c:pt idx="4">
                  <c:v>-0.52701809697307778</c:v>
                </c:pt>
                <c:pt idx="5">
                  <c:v>-1.0603065369643536</c:v>
                </c:pt>
                <c:pt idx="6">
                  <c:v>0.36893885131569509</c:v>
                </c:pt>
                <c:pt idx="7">
                  <c:v>2.1387915877332562</c:v>
                </c:pt>
                <c:pt idx="8">
                  <c:v>-0.82362501665341159</c:v>
                </c:pt>
                <c:pt idx="9">
                  <c:v>1.1516762867807506</c:v>
                </c:pt>
                <c:pt idx="10">
                  <c:v>-1.6893695524227157</c:v>
                </c:pt>
                <c:pt idx="11">
                  <c:v>2.5643355776737566</c:v>
                </c:pt>
              </c:numCache>
            </c:numRef>
          </c:val>
          <c:smooth val="0"/>
        </c:ser>
        <c:ser>
          <c:idx val="6"/>
          <c:order val="6"/>
          <c:spPr>
            <a:ln w="15875"/>
          </c:spPr>
          <c:cat>
            <c:strRef>
              <c:f>'OAvsART-3 imag'!$C$4:$N$4</c:f>
              <c:strCache>
                <c:ptCount val="12"/>
                <c:pt idx="1">
                  <c:v>CDT</c:v>
                </c:pt>
                <c:pt idx="2">
                  <c:v>WDT</c:v>
                </c:pt>
                <c:pt idx="3">
                  <c:v>TSL</c:v>
                </c:pt>
                <c:pt idx="4">
                  <c:v>CPT</c:v>
                </c:pt>
                <c:pt idx="5">
                  <c:v>HPT</c:v>
                </c:pt>
                <c:pt idx="6">
                  <c:v>MDT</c:v>
                </c:pt>
                <c:pt idx="7">
                  <c:v>MPT</c:v>
                </c:pt>
                <c:pt idx="8">
                  <c:v>MPS</c:v>
                </c:pt>
                <c:pt idx="9">
                  <c:v>WUR</c:v>
                </c:pt>
                <c:pt idx="10">
                  <c:v>VDT</c:v>
                </c:pt>
                <c:pt idx="11">
                  <c:v>PPT</c:v>
                </c:pt>
              </c:strCache>
            </c:strRef>
          </c:cat>
          <c:val>
            <c:numRef>
              <c:f>'OAvsART-3 imag'!$C$11:$N$11</c:f>
              <c:numCache>
                <c:formatCode>General</c:formatCode>
                <c:ptCount val="12"/>
                <c:pt idx="1">
                  <c:v>-0.7023029222584799</c:v>
                </c:pt>
                <c:pt idx="2">
                  <c:v>-0.92909663690511068</c:v>
                </c:pt>
                <c:pt idx="3">
                  <c:v>-1.9115267861724579</c:v>
                </c:pt>
                <c:pt idx="4">
                  <c:v>-1.3790553133510053</c:v>
                </c:pt>
                <c:pt idx="5">
                  <c:v>-1.3737984786109316</c:v>
                </c:pt>
                <c:pt idx="6">
                  <c:v>-3.2141215687384235</c:v>
                </c:pt>
                <c:pt idx="7">
                  <c:v>-1.0981893510614378</c:v>
                </c:pt>
                <c:pt idx="8">
                  <c:v>0.61699159404494652</c:v>
                </c:pt>
                <c:pt idx="9">
                  <c:v>-0.33307200686473454</c:v>
                </c:pt>
                <c:pt idx="10">
                  <c:v>0.84394479830840785</c:v>
                </c:pt>
                <c:pt idx="11">
                  <c:v>-0.72899287429691717</c:v>
                </c:pt>
              </c:numCache>
            </c:numRef>
          </c:val>
          <c:smooth val="0"/>
        </c:ser>
        <c:ser>
          <c:idx val="7"/>
          <c:order val="7"/>
          <c:spPr>
            <a:ln w="15875"/>
          </c:spPr>
          <c:cat>
            <c:strRef>
              <c:f>'OAvsART-3 imag'!$C$4:$N$4</c:f>
              <c:strCache>
                <c:ptCount val="12"/>
                <c:pt idx="1">
                  <c:v>CDT</c:v>
                </c:pt>
                <c:pt idx="2">
                  <c:v>WDT</c:v>
                </c:pt>
                <c:pt idx="3">
                  <c:v>TSL</c:v>
                </c:pt>
                <c:pt idx="4">
                  <c:v>CPT</c:v>
                </c:pt>
                <c:pt idx="5">
                  <c:v>HPT</c:v>
                </c:pt>
                <c:pt idx="6">
                  <c:v>MDT</c:v>
                </c:pt>
                <c:pt idx="7">
                  <c:v>MPT</c:v>
                </c:pt>
                <c:pt idx="8">
                  <c:v>MPS</c:v>
                </c:pt>
                <c:pt idx="9">
                  <c:v>WUR</c:v>
                </c:pt>
                <c:pt idx="10">
                  <c:v>VDT</c:v>
                </c:pt>
                <c:pt idx="11">
                  <c:v>PPT</c:v>
                </c:pt>
              </c:strCache>
            </c:strRef>
          </c:cat>
          <c:val>
            <c:numRef>
              <c:f>'OAvsART-3 imag'!$C$12:$N$12</c:f>
              <c:numCache>
                <c:formatCode>General</c:formatCode>
                <c:ptCount val="12"/>
                <c:pt idx="1">
                  <c:v>-0.20248523542906086</c:v>
                </c:pt>
                <c:pt idx="2">
                  <c:v>0.12067698308522232</c:v>
                </c:pt>
                <c:pt idx="3">
                  <c:v>-0.30795923488893756</c:v>
                </c:pt>
                <c:pt idx="4">
                  <c:v>-0.3498360458608481</c:v>
                </c:pt>
                <c:pt idx="5">
                  <c:v>1.7611209378548511</c:v>
                </c:pt>
                <c:pt idx="6">
                  <c:v>0.36893885131569509</c:v>
                </c:pt>
                <c:pt idx="7">
                  <c:v>1.8529236837708052</c:v>
                </c:pt>
                <c:pt idx="8">
                  <c:v>-1.5265234958351639</c:v>
                </c:pt>
                <c:pt idx="9">
                  <c:v>-1.1550261824178263</c:v>
                </c:pt>
                <c:pt idx="10">
                  <c:v>-0.67300990272819317</c:v>
                </c:pt>
                <c:pt idx="11">
                  <c:v>2.707814053357545</c:v>
                </c:pt>
              </c:numCache>
            </c:numRef>
          </c:val>
          <c:smooth val="0"/>
        </c:ser>
        <c:ser>
          <c:idx val="8"/>
          <c:order val="8"/>
          <c:spPr>
            <a:ln w="15875"/>
          </c:spPr>
          <c:cat>
            <c:strRef>
              <c:f>'OAvsART-3 imag'!$C$4:$N$4</c:f>
              <c:strCache>
                <c:ptCount val="12"/>
                <c:pt idx="1">
                  <c:v>CDT</c:v>
                </c:pt>
                <c:pt idx="2">
                  <c:v>WDT</c:v>
                </c:pt>
                <c:pt idx="3">
                  <c:v>TSL</c:v>
                </c:pt>
                <c:pt idx="4">
                  <c:v>CPT</c:v>
                </c:pt>
                <c:pt idx="5">
                  <c:v>HPT</c:v>
                </c:pt>
                <c:pt idx="6">
                  <c:v>MDT</c:v>
                </c:pt>
                <c:pt idx="7">
                  <c:v>MPT</c:v>
                </c:pt>
                <c:pt idx="8">
                  <c:v>MPS</c:v>
                </c:pt>
                <c:pt idx="9">
                  <c:v>WUR</c:v>
                </c:pt>
                <c:pt idx="10">
                  <c:v>VDT</c:v>
                </c:pt>
                <c:pt idx="11">
                  <c:v>PPT</c:v>
                </c:pt>
              </c:strCache>
            </c:strRef>
          </c:cat>
          <c:val>
            <c:numRef>
              <c:f>'OAvsART-3 imag'!$C$13:$N$13</c:f>
              <c:numCache>
                <c:formatCode>General</c:formatCode>
                <c:ptCount val="12"/>
                <c:pt idx="1">
                  <c:v>0.63174006194962862</c:v>
                </c:pt>
                <c:pt idx="2">
                  <c:v>0.91924703702487442</c:v>
                </c:pt>
                <c:pt idx="3">
                  <c:v>0.28206601834540002</c:v>
                </c:pt>
                <c:pt idx="4">
                  <c:v>0.85395965434282906</c:v>
                </c:pt>
                <c:pt idx="5">
                  <c:v>1.4341454718363751</c:v>
                </c:pt>
                <c:pt idx="6">
                  <c:v>0.65426678211990941</c:v>
                </c:pt>
                <c:pt idx="7">
                  <c:v>0.23461481147882271</c:v>
                </c:pt>
                <c:pt idx="8">
                  <c:v>0.9246006949203055</c:v>
                </c:pt>
                <c:pt idx="9">
                  <c:v>-0.98889341966148259</c:v>
                </c:pt>
                <c:pt idx="10">
                  <c:v>0.58606249913218578</c:v>
                </c:pt>
                <c:pt idx="11">
                  <c:v>3.1655982497759596</c:v>
                </c:pt>
              </c:numCache>
            </c:numRef>
          </c:val>
          <c:smooth val="0"/>
        </c:ser>
        <c:ser>
          <c:idx val="9"/>
          <c:order val="9"/>
          <c:spPr>
            <a:ln w="15875"/>
          </c:spPr>
          <c:cat>
            <c:strRef>
              <c:f>'OAvsART-3 imag'!$C$4:$N$4</c:f>
              <c:strCache>
                <c:ptCount val="12"/>
                <c:pt idx="1">
                  <c:v>CDT</c:v>
                </c:pt>
                <c:pt idx="2">
                  <c:v>WDT</c:v>
                </c:pt>
                <c:pt idx="3">
                  <c:v>TSL</c:v>
                </c:pt>
                <c:pt idx="4">
                  <c:v>CPT</c:v>
                </c:pt>
                <c:pt idx="5">
                  <c:v>HPT</c:v>
                </c:pt>
                <c:pt idx="6">
                  <c:v>MDT</c:v>
                </c:pt>
                <c:pt idx="7">
                  <c:v>MPT</c:v>
                </c:pt>
                <c:pt idx="8">
                  <c:v>MPS</c:v>
                </c:pt>
                <c:pt idx="9">
                  <c:v>WUR</c:v>
                </c:pt>
                <c:pt idx="10">
                  <c:v>VDT</c:v>
                </c:pt>
                <c:pt idx="11">
                  <c:v>PPT</c:v>
                </c:pt>
              </c:strCache>
            </c:strRef>
          </c:cat>
          <c:val>
            <c:numRef>
              <c:f>'OAvsART-3 imag'!$C$14:$N$14</c:f>
              <c:numCache>
                <c:formatCode>General</c:formatCode>
                <c:ptCount val="12"/>
                <c:pt idx="1">
                  <c:v>0.45231671575175758</c:v>
                </c:pt>
                <c:pt idx="2">
                  <c:v>-2.7428904895100137E-3</c:v>
                </c:pt>
                <c:pt idx="3">
                  <c:v>-5.6843317561627851E-3</c:v>
                </c:pt>
                <c:pt idx="4">
                  <c:v>1.7476867651001047</c:v>
                </c:pt>
                <c:pt idx="5">
                  <c:v>-1.8498737705304118E-3</c:v>
                </c:pt>
                <c:pt idx="6">
                  <c:v>-4.8104128684766625</c:v>
                </c:pt>
                <c:pt idx="7">
                  <c:v>3.1859969842655138</c:v>
                </c:pt>
                <c:pt idx="8">
                  <c:v>-1.4674909396487428</c:v>
                </c:pt>
                <c:pt idx="9">
                  <c:v>-0.73304820251216418</c:v>
                </c:pt>
                <c:pt idx="10">
                  <c:v>-1.4314872532464937</c:v>
                </c:pt>
                <c:pt idx="11">
                  <c:v>2.95679179039122</c:v>
                </c:pt>
              </c:numCache>
            </c:numRef>
          </c:val>
          <c:smooth val="0"/>
        </c:ser>
        <c:ser>
          <c:idx val="10"/>
          <c:order val="10"/>
          <c:spPr>
            <a:ln w="15875"/>
          </c:spPr>
          <c:cat>
            <c:strRef>
              <c:f>'OAvsART-3 imag'!$C$4:$N$4</c:f>
              <c:strCache>
                <c:ptCount val="12"/>
                <c:pt idx="1">
                  <c:v>CDT</c:v>
                </c:pt>
                <c:pt idx="2">
                  <c:v>WDT</c:v>
                </c:pt>
                <c:pt idx="3">
                  <c:v>TSL</c:v>
                </c:pt>
                <c:pt idx="4">
                  <c:v>CPT</c:v>
                </c:pt>
                <c:pt idx="5">
                  <c:v>HPT</c:v>
                </c:pt>
                <c:pt idx="6">
                  <c:v>MDT</c:v>
                </c:pt>
                <c:pt idx="7">
                  <c:v>MPT</c:v>
                </c:pt>
                <c:pt idx="8">
                  <c:v>MPS</c:v>
                </c:pt>
                <c:pt idx="9">
                  <c:v>WUR</c:v>
                </c:pt>
                <c:pt idx="10">
                  <c:v>VDT</c:v>
                </c:pt>
                <c:pt idx="11">
                  <c:v>PPT</c:v>
                </c:pt>
              </c:strCache>
            </c:strRef>
          </c:cat>
          <c:val>
            <c:numRef>
              <c:f>'OAvsART-3 imag'!$C$15:$N$15</c:f>
              <c:numCache>
                <c:formatCode>General</c:formatCode>
                <c:ptCount val="12"/>
                <c:pt idx="1">
                  <c:v>0.52724838051323653</c:v>
                </c:pt>
                <c:pt idx="2">
                  <c:v>-0.56586122733266098</c:v>
                </c:pt>
                <c:pt idx="3">
                  <c:v>-1.0596928742193259</c:v>
                </c:pt>
                <c:pt idx="4">
                  <c:v>-0.47099730140082857</c:v>
                </c:pt>
                <c:pt idx="5">
                  <c:v>7.5680391367871969E-2</c:v>
                </c:pt>
                <c:pt idx="6">
                  <c:v>-0.43251272083702336</c:v>
                </c:pt>
                <c:pt idx="7">
                  <c:v>-0.90778450547562484</c:v>
                </c:pt>
                <c:pt idx="8">
                  <c:v>-2.0871888601392084E-2</c:v>
                </c:pt>
                <c:pt idx="9">
                  <c:v>-0.92588773040188221</c:v>
                </c:pt>
                <c:pt idx="10">
                  <c:v>0.58606249913218578</c:v>
                </c:pt>
                <c:pt idx="11">
                  <c:v>2.9059640832632296</c:v>
                </c:pt>
              </c:numCache>
            </c:numRef>
          </c:val>
          <c:smooth val="0"/>
        </c:ser>
        <c:ser>
          <c:idx val="11"/>
          <c:order val="11"/>
          <c:spPr>
            <a:ln w="15875">
              <a:solidFill>
                <a:sysClr val="window" lastClr="FFFFFF">
                  <a:lumMod val="65000"/>
                </a:sysClr>
              </a:solidFill>
            </a:ln>
          </c:spPr>
          <c:marker>
            <c:symbol val="diamond"/>
            <c:size val="5"/>
            <c:spPr>
              <a:solidFill>
                <a:sysClr val="window" lastClr="FFFFFF">
                  <a:lumMod val="65000"/>
                </a:sysClr>
              </a:solidFill>
              <a:ln>
                <a:solidFill>
                  <a:sysClr val="window" lastClr="FFFFFF">
                    <a:lumMod val="65000"/>
                  </a:sysClr>
                </a:solidFill>
              </a:ln>
            </c:spPr>
          </c:marker>
          <c:cat>
            <c:strRef>
              <c:f>'OAvsART-3 imag'!$C$4:$N$4</c:f>
              <c:strCache>
                <c:ptCount val="12"/>
                <c:pt idx="1">
                  <c:v>CDT</c:v>
                </c:pt>
                <c:pt idx="2">
                  <c:v>WDT</c:v>
                </c:pt>
                <c:pt idx="3">
                  <c:v>TSL</c:v>
                </c:pt>
                <c:pt idx="4">
                  <c:v>CPT</c:v>
                </c:pt>
                <c:pt idx="5">
                  <c:v>HPT</c:v>
                </c:pt>
                <c:pt idx="6">
                  <c:v>MDT</c:v>
                </c:pt>
                <c:pt idx="7">
                  <c:v>MPT</c:v>
                </c:pt>
                <c:pt idx="8">
                  <c:v>MPS</c:v>
                </c:pt>
                <c:pt idx="9">
                  <c:v>WUR</c:v>
                </c:pt>
                <c:pt idx="10">
                  <c:v>VDT</c:v>
                </c:pt>
                <c:pt idx="11">
                  <c:v>PPT</c:v>
                </c:pt>
              </c:strCache>
            </c:strRef>
          </c:cat>
          <c:val>
            <c:numRef>
              <c:f>'OAvsART-3 imag'!$C$16:$N$16</c:f>
              <c:numCache>
                <c:formatCode>General</c:formatCode>
                <c:ptCount val="12"/>
                <c:pt idx="1">
                  <c:v>-0.86077358798645276</c:v>
                </c:pt>
                <c:pt idx="2">
                  <c:v>-6.9198135683814206</c:v>
                </c:pt>
                <c:pt idx="3">
                  <c:v>-2.630941926742175</c:v>
                </c:pt>
                <c:pt idx="4">
                  <c:v>-0.91786085677946649</c:v>
                </c:pt>
                <c:pt idx="5">
                  <c:v>-2.1726972976457586</c:v>
                </c:pt>
                <c:pt idx="6">
                  <c:v>-3.0756036916272249</c:v>
                </c:pt>
                <c:pt idx="7">
                  <c:v>-0.6221750433845562</c:v>
                </c:pt>
                <c:pt idx="8">
                  <c:v>-1.4851446825661871</c:v>
                </c:pt>
                <c:pt idx="9">
                  <c:v>1.1280071067231459</c:v>
                </c:pt>
                <c:pt idx="10">
                  <c:v>-3.206324253459317</c:v>
                </c:pt>
                <c:pt idx="11">
                  <c:v>1.7825425079325663</c:v>
                </c:pt>
              </c:numCache>
            </c:numRef>
          </c:val>
          <c:smooth val="0"/>
        </c:ser>
        <c:ser>
          <c:idx val="12"/>
          <c:order val="12"/>
          <c:spPr>
            <a:ln w="19050"/>
          </c:spPr>
          <c:cat>
            <c:strRef>
              <c:f>'OAvsART-3 imag'!$C$4:$N$4</c:f>
              <c:strCache>
                <c:ptCount val="12"/>
                <c:pt idx="1">
                  <c:v>CDT</c:v>
                </c:pt>
                <c:pt idx="2">
                  <c:v>WDT</c:v>
                </c:pt>
                <c:pt idx="3">
                  <c:v>TSL</c:v>
                </c:pt>
                <c:pt idx="4">
                  <c:v>CPT</c:v>
                </c:pt>
                <c:pt idx="5">
                  <c:v>HPT</c:v>
                </c:pt>
                <c:pt idx="6">
                  <c:v>MDT</c:v>
                </c:pt>
                <c:pt idx="7">
                  <c:v>MPT</c:v>
                </c:pt>
                <c:pt idx="8">
                  <c:v>MPS</c:v>
                </c:pt>
                <c:pt idx="9">
                  <c:v>WUR</c:v>
                </c:pt>
                <c:pt idx="10">
                  <c:v>VDT</c:v>
                </c:pt>
                <c:pt idx="11">
                  <c:v>PPT</c:v>
                </c:pt>
              </c:strCache>
            </c:strRef>
          </c:cat>
          <c:val>
            <c:numRef>
              <c:f>'OAvsART-3 imag'!$C$17:$N$17</c:f>
              <c:numCache>
                <c:formatCode>General</c:formatCode>
                <c:ptCount val="12"/>
                <c:pt idx="1">
                  <c:v>-0.38863320992790895</c:v>
                </c:pt>
                <c:pt idx="2">
                  <c:v>-1.2892256623020872</c:v>
                </c:pt>
                <c:pt idx="3">
                  <c:v>-1.4993591487296374</c:v>
                </c:pt>
                <c:pt idx="4">
                  <c:v>2.0082486049710302</c:v>
                </c:pt>
                <c:pt idx="5">
                  <c:v>0.79367806417132358</c:v>
                </c:pt>
                <c:pt idx="6">
                  <c:v>-3.7412975246831932</c:v>
                </c:pt>
                <c:pt idx="7">
                  <c:v>0.80580691893639533</c:v>
                </c:pt>
                <c:pt idx="8">
                  <c:v>-0.74690565798622033</c:v>
                </c:pt>
                <c:pt idx="9">
                  <c:v>0.18686658607384576</c:v>
                </c:pt>
                <c:pt idx="10">
                  <c:v>1.0866575504742642</c:v>
                </c:pt>
                <c:pt idx="11">
                  <c:v>2.2895073711866192</c:v>
                </c:pt>
              </c:numCache>
            </c:numRef>
          </c:val>
          <c:smooth val="0"/>
        </c:ser>
        <c:ser>
          <c:idx val="13"/>
          <c:order val="13"/>
          <c:spPr>
            <a:ln w="15875"/>
          </c:spPr>
          <c:cat>
            <c:strRef>
              <c:f>'OAvsART-3 imag'!$C$4:$N$4</c:f>
              <c:strCache>
                <c:ptCount val="12"/>
                <c:pt idx="1">
                  <c:v>CDT</c:v>
                </c:pt>
                <c:pt idx="2">
                  <c:v>WDT</c:v>
                </c:pt>
                <c:pt idx="3">
                  <c:v>TSL</c:v>
                </c:pt>
                <c:pt idx="4">
                  <c:v>CPT</c:v>
                </c:pt>
                <c:pt idx="5">
                  <c:v>HPT</c:v>
                </c:pt>
                <c:pt idx="6">
                  <c:v>MDT</c:v>
                </c:pt>
                <c:pt idx="7">
                  <c:v>MPT</c:v>
                </c:pt>
                <c:pt idx="8">
                  <c:v>MPS</c:v>
                </c:pt>
                <c:pt idx="9">
                  <c:v>WUR</c:v>
                </c:pt>
                <c:pt idx="10">
                  <c:v>VDT</c:v>
                </c:pt>
                <c:pt idx="11">
                  <c:v>PPT</c:v>
                </c:pt>
              </c:strCache>
            </c:strRef>
          </c:cat>
          <c:val>
            <c:numRef>
              <c:f>'OAvsART-3 imag'!$C$18:$N$18</c:f>
              <c:numCache>
                <c:formatCode>General</c:formatCode>
                <c:ptCount val="12"/>
                <c:pt idx="1">
                  <c:v>-0.12537059799825581</c:v>
                </c:pt>
                <c:pt idx="2">
                  <c:v>-0.92909663690511068</c:v>
                </c:pt>
                <c:pt idx="3">
                  <c:v>-0.47657337828120666</c:v>
                </c:pt>
                <c:pt idx="4">
                  <c:v>1.6043777531710957</c:v>
                </c:pt>
                <c:pt idx="5">
                  <c:v>2.0645002362225071</c:v>
                </c:pt>
                <c:pt idx="6">
                  <c:v>-1.211993359027393</c:v>
                </c:pt>
                <c:pt idx="7">
                  <c:v>1.186627321824208</c:v>
                </c:pt>
                <c:pt idx="8">
                  <c:v>0.11804897439232666</c:v>
                </c:pt>
                <c:pt idx="9">
                  <c:v>0.89569931806037184</c:v>
                </c:pt>
                <c:pt idx="10">
                  <c:v>-1.9472518515989379</c:v>
                </c:pt>
                <c:pt idx="11">
                  <c:v>3.2192341731686369</c:v>
                </c:pt>
              </c:numCache>
            </c:numRef>
          </c:val>
          <c:smooth val="0"/>
        </c:ser>
        <c:ser>
          <c:idx val="14"/>
          <c:order val="14"/>
          <c:spPr>
            <a:ln w="15875"/>
          </c:spPr>
          <c:cat>
            <c:strRef>
              <c:f>'OAvsART-3 imag'!$C$4:$N$4</c:f>
              <c:strCache>
                <c:ptCount val="12"/>
                <c:pt idx="1">
                  <c:v>CDT</c:v>
                </c:pt>
                <c:pt idx="2">
                  <c:v>WDT</c:v>
                </c:pt>
                <c:pt idx="3">
                  <c:v>TSL</c:v>
                </c:pt>
                <c:pt idx="4">
                  <c:v>CPT</c:v>
                </c:pt>
                <c:pt idx="5">
                  <c:v>HPT</c:v>
                </c:pt>
                <c:pt idx="6">
                  <c:v>MDT</c:v>
                </c:pt>
                <c:pt idx="7">
                  <c:v>MPT</c:v>
                </c:pt>
                <c:pt idx="8">
                  <c:v>MPS</c:v>
                </c:pt>
                <c:pt idx="9">
                  <c:v>WUR</c:v>
                </c:pt>
                <c:pt idx="10">
                  <c:v>VDT</c:v>
                </c:pt>
                <c:pt idx="11">
                  <c:v>PPT</c:v>
                </c:pt>
              </c:strCache>
            </c:strRef>
          </c:cat>
          <c:val>
            <c:numRef>
              <c:f>'OAvsART-3 imag'!$C$19:$N$19</c:f>
              <c:numCache>
                <c:formatCode>General</c:formatCode>
                <c:ptCount val="12"/>
                <c:pt idx="1">
                  <c:v>0.52724838051323653</c:v>
                </c:pt>
                <c:pt idx="2">
                  <c:v>-7.6621559824744556E-2</c:v>
                </c:pt>
                <c:pt idx="3">
                  <c:v>-0.7038740861336773</c:v>
                </c:pt>
                <c:pt idx="4">
                  <c:v>1.7607148570936511</c:v>
                </c:pt>
                <c:pt idx="5">
                  <c:v>0.94199683226217934</c:v>
                </c:pt>
                <c:pt idx="6">
                  <c:v>-0.15067695411175486</c:v>
                </c:pt>
                <c:pt idx="7">
                  <c:v>-0.52697721670428554</c:v>
                </c:pt>
                <c:pt idx="8">
                  <c:v>-0.43392197194132809</c:v>
                </c:pt>
                <c:pt idx="9">
                  <c:v>0.90892182301054492</c:v>
                </c:pt>
                <c:pt idx="10">
                  <c:v>0.58606249913218333</c:v>
                </c:pt>
                <c:pt idx="11">
                  <c:v>2.334245030532609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02408160"/>
        <c:axId val="502412512"/>
      </c:lineChart>
      <c:catAx>
        <c:axId val="50240816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 w="19050">
            <a:solidFill>
              <a:sysClr val="windowText" lastClr="000000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502412512"/>
        <c:crossesAt val="-10"/>
        <c:auto val="1"/>
        <c:lblAlgn val="ctr"/>
        <c:lblOffset val="100"/>
        <c:noMultiLvlLbl val="0"/>
      </c:catAx>
      <c:valAx>
        <c:axId val="502412512"/>
        <c:scaling>
          <c:orientation val="minMax"/>
          <c:max val="10"/>
          <c:min val="-1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19050">
            <a:solidFill>
              <a:sysClr val="windowText" lastClr="000000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502408160"/>
        <c:crosses val="autoZero"/>
        <c:crossBetween val="midCat"/>
      </c:valAx>
    </c:plotArea>
    <c:plotVisOnly val="1"/>
    <c:dispBlanksAs val="gap"/>
    <c:showDLblsOverMax val="0"/>
  </c:chart>
  <c:spPr>
    <a:ln>
      <a:noFill/>
    </a:ln>
  </c:sp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Graphs'!$C$106:$H$106</c:f>
                <c:numCache>
                  <c:formatCode>General</c:formatCode>
                  <c:ptCount val="6"/>
                  <c:pt idx="0">
                    <c:v>6.6161067979437114</c:v>
                  </c:pt>
                  <c:pt idx="1">
                    <c:v>5.8566256535280088</c:v>
                  </c:pt>
                  <c:pt idx="2">
                    <c:v>10.2695407699483</c:v>
                  </c:pt>
                  <c:pt idx="3">
                    <c:v>11.127704204049799</c:v>
                  </c:pt>
                  <c:pt idx="4">
                    <c:v>17.733596721333694</c:v>
                  </c:pt>
                  <c:pt idx="5">
                    <c:v>17.109848438260549</c:v>
                  </c:pt>
                </c:numCache>
              </c:numRef>
            </c:plus>
            <c:minus>
              <c:numRef>
                <c:f>'[Chart in Microsoft PowerPoint]Graphs'!$C$106:$H$106</c:f>
                <c:numCache>
                  <c:formatCode>General</c:formatCode>
                  <c:ptCount val="6"/>
                  <c:pt idx="0">
                    <c:v>6.6161067979437114</c:v>
                  </c:pt>
                  <c:pt idx="1">
                    <c:v>5.8566256535280088</c:v>
                  </c:pt>
                  <c:pt idx="2">
                    <c:v>10.2695407699483</c:v>
                  </c:pt>
                  <c:pt idx="3">
                    <c:v>11.127704204049799</c:v>
                  </c:pt>
                  <c:pt idx="4">
                    <c:v>17.733596721333694</c:v>
                  </c:pt>
                  <c:pt idx="5">
                    <c:v>17.109848438260549</c:v>
                  </c:pt>
                </c:numCache>
              </c:numRef>
            </c:minus>
          </c:errBars>
          <c:cat>
            <c:strRef>
              <c:f>'[Chart in Microsoft PowerPoint]Graphs'!$C$102:$H$102</c:f>
              <c:strCache>
                <c:ptCount val="6"/>
                <c:pt idx="0">
                  <c:v>Controls NW</c:v>
                </c:pt>
                <c:pt idx="1">
                  <c:v>Controls IW</c:v>
                </c:pt>
                <c:pt idx="2">
                  <c:v>Art pts   NW</c:v>
                </c:pt>
                <c:pt idx="3">
                  <c:v>Art pts   IW</c:v>
                </c:pt>
                <c:pt idx="4">
                  <c:v>OA pts NW</c:v>
                </c:pt>
                <c:pt idx="5">
                  <c:v>OA pts   IW</c:v>
                </c:pt>
              </c:strCache>
            </c:strRef>
          </c:cat>
          <c:val>
            <c:numRef>
              <c:f>'[Chart in Microsoft PowerPoint]Graphs'!$C$103:$H$103</c:f>
              <c:numCache>
                <c:formatCode>General</c:formatCode>
                <c:ptCount val="6"/>
                <c:pt idx="0">
                  <c:v>164.55284552845529</c:v>
                </c:pt>
                <c:pt idx="1">
                  <c:v>161.92682926829269</c:v>
                </c:pt>
                <c:pt idx="2">
                  <c:v>117.33333333333333</c:v>
                </c:pt>
                <c:pt idx="3">
                  <c:v>118.16666666666667</c:v>
                </c:pt>
                <c:pt idx="4">
                  <c:v>98.777777777777771</c:v>
                </c:pt>
                <c:pt idx="5">
                  <c:v>97</c:v>
                </c:pt>
              </c:numCache>
            </c:numRef>
          </c:val>
        </c:ser>
        <c:ser>
          <c:idx val="1"/>
          <c:order val="1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Graphs'!$C$107:$H$107</c:f>
                <c:numCache>
                  <c:formatCode>General</c:formatCode>
                  <c:ptCount val="6"/>
                  <c:pt idx="0">
                    <c:v>6.56213376309009</c:v>
                  </c:pt>
                  <c:pt idx="1">
                    <c:v>8.4393449064506036</c:v>
                  </c:pt>
                  <c:pt idx="2">
                    <c:v>10.25571388747899</c:v>
                  </c:pt>
                  <c:pt idx="3">
                    <c:v>12.879267647489526</c:v>
                  </c:pt>
                  <c:pt idx="4">
                    <c:v>19.927078997340651</c:v>
                  </c:pt>
                  <c:pt idx="5">
                    <c:v>25.740074598361616</c:v>
                  </c:pt>
                </c:numCache>
              </c:numRef>
            </c:plus>
            <c:minus>
              <c:numRef>
                <c:f>'[Chart in Microsoft PowerPoint]Graphs'!$C$107:$H$107</c:f>
                <c:numCache>
                  <c:formatCode>General</c:formatCode>
                  <c:ptCount val="6"/>
                  <c:pt idx="0">
                    <c:v>6.56213376309009</c:v>
                  </c:pt>
                  <c:pt idx="1">
                    <c:v>8.4393449064506036</c:v>
                  </c:pt>
                  <c:pt idx="2">
                    <c:v>10.25571388747899</c:v>
                  </c:pt>
                  <c:pt idx="3">
                    <c:v>12.879267647489526</c:v>
                  </c:pt>
                  <c:pt idx="4">
                    <c:v>19.927078997340651</c:v>
                  </c:pt>
                  <c:pt idx="5">
                    <c:v>25.740074598361616</c:v>
                  </c:pt>
                </c:numCache>
              </c:numRef>
            </c:minus>
          </c:errBars>
          <c:cat>
            <c:strRef>
              <c:f>'[Chart in Microsoft PowerPoint]Graphs'!$C$102:$H$102</c:f>
              <c:strCache>
                <c:ptCount val="6"/>
                <c:pt idx="0">
                  <c:v>Controls NW</c:v>
                </c:pt>
                <c:pt idx="1">
                  <c:v>Controls IW</c:v>
                </c:pt>
                <c:pt idx="2">
                  <c:v>Art pts   NW</c:v>
                </c:pt>
                <c:pt idx="3">
                  <c:v>Art pts   IW</c:v>
                </c:pt>
                <c:pt idx="4">
                  <c:v>OA pts NW</c:v>
                </c:pt>
                <c:pt idx="5">
                  <c:v>OA pts   IW</c:v>
                </c:pt>
              </c:strCache>
            </c:strRef>
          </c:cat>
          <c:val>
            <c:numRef>
              <c:f>'[Chart in Microsoft PowerPoint]Graphs'!$C$104:$H$104</c:f>
              <c:numCache>
                <c:formatCode>General</c:formatCode>
                <c:ptCount val="6"/>
                <c:pt idx="0">
                  <c:v>168.3821138211382</c:v>
                </c:pt>
                <c:pt idx="1">
                  <c:v>214.04878048780489</c:v>
                </c:pt>
                <c:pt idx="2">
                  <c:v>118.52380952380956</c:v>
                </c:pt>
                <c:pt idx="3">
                  <c:v>141.52023809523811</c:v>
                </c:pt>
                <c:pt idx="4">
                  <c:v>96.8888888888889</c:v>
                </c:pt>
                <c:pt idx="5">
                  <c:v>141.11111111111123</c:v>
                </c:pt>
              </c:numCache>
            </c:numRef>
          </c:val>
        </c:ser>
        <c:ser>
          <c:idx val="2"/>
          <c:order val="2"/>
          <c:spPr>
            <a:solidFill>
              <a:schemeClr val="bg1">
                <a:lumMod val="8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Graphs'!$C$108:$H$108</c:f>
                <c:numCache>
                  <c:formatCode>General</c:formatCode>
                  <c:ptCount val="6"/>
                  <c:pt idx="0">
                    <c:v>7.2048082827347715</c:v>
                  </c:pt>
                  <c:pt idx="1">
                    <c:v>6.6250175268693505</c:v>
                  </c:pt>
                  <c:pt idx="2">
                    <c:v>10.738216566964207</c:v>
                  </c:pt>
                  <c:pt idx="3">
                    <c:v>10.2695407699483</c:v>
                  </c:pt>
                  <c:pt idx="4">
                    <c:v>21.793505720501621</c:v>
                  </c:pt>
                  <c:pt idx="5">
                    <c:v>17.733596721333694</c:v>
                  </c:pt>
                </c:numCache>
              </c:numRef>
            </c:plus>
            <c:minus>
              <c:numRef>
                <c:f>'[Chart in Microsoft PowerPoint]Graphs'!$C$108:$H$108</c:f>
                <c:numCache>
                  <c:formatCode>General</c:formatCode>
                  <c:ptCount val="6"/>
                  <c:pt idx="0">
                    <c:v>7.2048082827347715</c:v>
                  </c:pt>
                  <c:pt idx="1">
                    <c:v>6.6250175268693505</c:v>
                  </c:pt>
                  <c:pt idx="2">
                    <c:v>10.738216566964207</c:v>
                  </c:pt>
                  <c:pt idx="3">
                    <c:v>10.2695407699483</c:v>
                  </c:pt>
                  <c:pt idx="4">
                    <c:v>21.793505720501621</c:v>
                  </c:pt>
                  <c:pt idx="5">
                    <c:v>17.733596721333694</c:v>
                  </c:pt>
                </c:numCache>
              </c:numRef>
            </c:minus>
          </c:errBars>
          <c:cat>
            <c:strRef>
              <c:f>'[Chart in Microsoft PowerPoint]Graphs'!$C$102:$H$102</c:f>
              <c:strCache>
                <c:ptCount val="6"/>
                <c:pt idx="0">
                  <c:v>Controls NW</c:v>
                </c:pt>
                <c:pt idx="1">
                  <c:v>Controls IW</c:v>
                </c:pt>
                <c:pt idx="2">
                  <c:v>Art pts   NW</c:v>
                </c:pt>
                <c:pt idx="3">
                  <c:v>Art pts   IW</c:v>
                </c:pt>
                <c:pt idx="4">
                  <c:v>OA pts NW</c:v>
                </c:pt>
                <c:pt idx="5">
                  <c:v>OA pts   IW</c:v>
                </c:pt>
              </c:strCache>
            </c:strRef>
          </c:cat>
          <c:val>
            <c:numRef>
              <c:f>'[Chart in Microsoft PowerPoint]Graphs'!$C$105:$H$105</c:f>
              <c:numCache>
                <c:formatCode>General</c:formatCode>
                <c:ptCount val="6"/>
                <c:pt idx="0">
                  <c:v>167.11382113821139</c:v>
                </c:pt>
                <c:pt idx="1">
                  <c:v>164.59349593495935</c:v>
                </c:pt>
                <c:pt idx="2">
                  <c:v>120.92857142857143</c:v>
                </c:pt>
                <c:pt idx="3">
                  <c:v>117.33333333333333</c:v>
                </c:pt>
                <c:pt idx="4">
                  <c:v>104.38889444444446</c:v>
                </c:pt>
                <c:pt idx="5">
                  <c:v>98.77777777777777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02397280"/>
        <c:axId val="502400544"/>
      </c:barChart>
      <c:catAx>
        <c:axId val="502397280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b="1">
                <a:latin typeface="+mn-lt"/>
                <a:cs typeface="Times New Roman" panose="02020603050405020304" pitchFamily="18" charset="0"/>
              </a:defRPr>
            </a:pPr>
            <a:endParaRPr lang="en-US"/>
          </a:p>
        </c:txPr>
        <c:crossAx val="502400544"/>
        <c:crosses val="autoZero"/>
        <c:auto val="1"/>
        <c:lblAlgn val="ctr"/>
        <c:lblOffset val="100"/>
        <c:noMultiLvlLbl val="0"/>
      </c:catAx>
      <c:valAx>
        <c:axId val="50240054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b="1">
                <a:latin typeface="+mn-lt"/>
                <a:cs typeface="Times New Roman" panose="02020603050405020304" pitchFamily="18" charset="0"/>
              </a:defRPr>
            </a:pPr>
            <a:endParaRPr lang="en-US"/>
          </a:p>
        </c:txPr>
        <c:crossAx val="50239728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Graphs'!$N$106:$S$106</c:f>
                <c:numCache>
                  <c:formatCode>General</c:formatCode>
                  <c:ptCount val="6"/>
                  <c:pt idx="0">
                    <c:v>20.016687807230902</c:v>
                  </c:pt>
                  <c:pt idx="1">
                    <c:v>17.792823699698392</c:v>
                  </c:pt>
                  <c:pt idx="2">
                    <c:v>22.885692910007233</c:v>
                  </c:pt>
                  <c:pt idx="3">
                    <c:v>20.947103576404203</c:v>
                  </c:pt>
                  <c:pt idx="4">
                    <c:v>33.17246095239036</c:v>
                  </c:pt>
                  <c:pt idx="5">
                    <c:v>23.65628847828631</c:v>
                  </c:pt>
                </c:numCache>
              </c:numRef>
            </c:plus>
            <c:minus>
              <c:numRef>
                <c:f>'[Chart in Microsoft PowerPoint]Graphs'!$N$106:$S$106</c:f>
                <c:numCache>
                  <c:formatCode>General</c:formatCode>
                  <c:ptCount val="6"/>
                  <c:pt idx="0">
                    <c:v>20.016687807230902</c:v>
                  </c:pt>
                  <c:pt idx="1">
                    <c:v>17.792823699698392</c:v>
                  </c:pt>
                  <c:pt idx="2">
                    <c:v>22.885692910007233</c:v>
                  </c:pt>
                  <c:pt idx="3">
                    <c:v>20.947103576404203</c:v>
                  </c:pt>
                  <c:pt idx="4">
                    <c:v>33.17246095239036</c:v>
                  </c:pt>
                  <c:pt idx="5">
                    <c:v>23.65628847828631</c:v>
                  </c:pt>
                </c:numCache>
              </c:numRef>
            </c:minus>
          </c:errBars>
          <c:cat>
            <c:strRef>
              <c:f>'[Chart in Microsoft PowerPoint]Graphs'!$N$102:$S$102</c:f>
              <c:strCache>
                <c:ptCount val="6"/>
                <c:pt idx="0">
                  <c:v>Controls NW</c:v>
                </c:pt>
                <c:pt idx="1">
                  <c:v>Controls IW</c:v>
                </c:pt>
                <c:pt idx="2">
                  <c:v>Art pts   NW</c:v>
                </c:pt>
                <c:pt idx="3">
                  <c:v>Art pts   IW</c:v>
                </c:pt>
                <c:pt idx="4">
                  <c:v>OA pts NW</c:v>
                </c:pt>
                <c:pt idx="5">
                  <c:v>OA pts   IW</c:v>
                </c:pt>
              </c:strCache>
            </c:strRef>
          </c:cat>
          <c:val>
            <c:numRef>
              <c:f>'[Chart in Microsoft PowerPoint]Graphs'!$N$103:$S$103</c:f>
              <c:numCache>
                <c:formatCode>General</c:formatCode>
                <c:ptCount val="6"/>
                <c:pt idx="0">
                  <c:v>452.34146341463412</c:v>
                </c:pt>
                <c:pt idx="1">
                  <c:v>457.4552845528454</c:v>
                </c:pt>
                <c:pt idx="2">
                  <c:v>381</c:v>
                </c:pt>
                <c:pt idx="3">
                  <c:v>378.64285714285717</c:v>
                </c:pt>
                <c:pt idx="4">
                  <c:v>278.38888888888886</c:v>
                </c:pt>
                <c:pt idx="5">
                  <c:v>281.16666666666669</c:v>
                </c:pt>
              </c:numCache>
            </c:numRef>
          </c:val>
        </c:ser>
        <c:ser>
          <c:idx val="1"/>
          <c:order val="1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Graphs'!$N$107:$S$107</c:f>
                <c:numCache>
                  <c:formatCode>General</c:formatCode>
                  <c:ptCount val="6"/>
                  <c:pt idx="0">
                    <c:v>18.672910543224805</c:v>
                  </c:pt>
                  <c:pt idx="1">
                    <c:v>18.301653120392007</c:v>
                  </c:pt>
                  <c:pt idx="2">
                    <c:v>22.230376305319595</c:v>
                  </c:pt>
                  <c:pt idx="3">
                    <c:v>21.379786590675927</c:v>
                  </c:pt>
                  <c:pt idx="4">
                    <c:v>20.20854810882421</c:v>
                  </c:pt>
                  <c:pt idx="5">
                    <c:v>25.224519086966129</c:v>
                  </c:pt>
                </c:numCache>
              </c:numRef>
            </c:plus>
            <c:minus>
              <c:numRef>
                <c:f>'[Chart in Microsoft PowerPoint]Graphs'!$N$107:$S$107</c:f>
                <c:numCache>
                  <c:formatCode>General</c:formatCode>
                  <c:ptCount val="6"/>
                  <c:pt idx="0">
                    <c:v>18.672910543224805</c:v>
                  </c:pt>
                  <c:pt idx="1">
                    <c:v>18.301653120392007</c:v>
                  </c:pt>
                  <c:pt idx="2">
                    <c:v>22.230376305319595</c:v>
                  </c:pt>
                  <c:pt idx="3">
                    <c:v>21.379786590675927</c:v>
                  </c:pt>
                  <c:pt idx="4">
                    <c:v>20.20854810882421</c:v>
                  </c:pt>
                  <c:pt idx="5">
                    <c:v>25.224519086966129</c:v>
                  </c:pt>
                </c:numCache>
              </c:numRef>
            </c:minus>
          </c:errBars>
          <c:cat>
            <c:strRef>
              <c:f>'[Chart in Microsoft PowerPoint]Graphs'!$N$102:$S$102</c:f>
              <c:strCache>
                <c:ptCount val="6"/>
                <c:pt idx="0">
                  <c:v>Controls NW</c:v>
                </c:pt>
                <c:pt idx="1">
                  <c:v>Controls IW</c:v>
                </c:pt>
                <c:pt idx="2">
                  <c:v>Art pts   NW</c:v>
                </c:pt>
                <c:pt idx="3">
                  <c:v>Art pts   IW</c:v>
                </c:pt>
                <c:pt idx="4">
                  <c:v>OA pts NW</c:v>
                </c:pt>
                <c:pt idx="5">
                  <c:v>OA pts   IW</c:v>
                </c:pt>
              </c:strCache>
            </c:strRef>
          </c:cat>
          <c:val>
            <c:numRef>
              <c:f>'[Chart in Microsoft PowerPoint]Graphs'!$N$104:$S$104</c:f>
              <c:numCache>
                <c:formatCode>General</c:formatCode>
                <c:ptCount val="6"/>
                <c:pt idx="0">
                  <c:v>438.49593495934954</c:v>
                </c:pt>
                <c:pt idx="1">
                  <c:v>510.17886178861778</c:v>
                </c:pt>
                <c:pt idx="2">
                  <c:v>375.26190476190476</c:v>
                </c:pt>
                <c:pt idx="3">
                  <c:v>411.21428571428567</c:v>
                </c:pt>
                <c:pt idx="4">
                  <c:v>257.83333333333337</c:v>
                </c:pt>
                <c:pt idx="5">
                  <c:v>331.94444444444451</c:v>
                </c:pt>
              </c:numCache>
            </c:numRef>
          </c:val>
        </c:ser>
        <c:ser>
          <c:idx val="2"/>
          <c:order val="2"/>
          <c:spPr>
            <a:solidFill>
              <a:schemeClr val="bg1">
                <a:lumMod val="85000"/>
              </a:schemeClr>
            </a:solidFill>
            <a:ln>
              <a:solidFill>
                <a:sysClr val="windowText" lastClr="000000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[Chart in Microsoft PowerPoint]Graphs'!$N$108:$S$108</c:f>
                <c:numCache>
                  <c:formatCode>General</c:formatCode>
                  <c:ptCount val="6"/>
                  <c:pt idx="0">
                    <c:v>18.702191494624405</c:v>
                  </c:pt>
                  <c:pt idx="1">
                    <c:v>19.019988680499676</c:v>
                  </c:pt>
                  <c:pt idx="2">
                    <c:v>21.75291375823118</c:v>
                  </c:pt>
                  <c:pt idx="3">
                    <c:v>22.885692910007233</c:v>
                  </c:pt>
                  <c:pt idx="4">
                    <c:v>20.334206113630547</c:v>
                  </c:pt>
                  <c:pt idx="5">
                    <c:v>33.17246095239036</c:v>
                  </c:pt>
                </c:numCache>
              </c:numRef>
            </c:plus>
            <c:minus>
              <c:numRef>
                <c:f>'[Chart in Microsoft PowerPoint]Graphs'!$N$108:$S$108</c:f>
                <c:numCache>
                  <c:formatCode>General</c:formatCode>
                  <c:ptCount val="6"/>
                  <c:pt idx="0">
                    <c:v>18.702191494624405</c:v>
                  </c:pt>
                  <c:pt idx="1">
                    <c:v>19.019988680499676</c:v>
                  </c:pt>
                  <c:pt idx="2">
                    <c:v>21.75291375823118</c:v>
                  </c:pt>
                  <c:pt idx="3">
                    <c:v>22.885692910007233</c:v>
                  </c:pt>
                  <c:pt idx="4">
                    <c:v>20.334206113630547</c:v>
                  </c:pt>
                  <c:pt idx="5">
                    <c:v>33.17246095239036</c:v>
                  </c:pt>
                </c:numCache>
              </c:numRef>
            </c:minus>
          </c:errBars>
          <c:cat>
            <c:strRef>
              <c:f>'[Chart in Microsoft PowerPoint]Graphs'!$N$102:$S$102</c:f>
              <c:strCache>
                <c:ptCount val="6"/>
                <c:pt idx="0">
                  <c:v>Controls NW</c:v>
                </c:pt>
                <c:pt idx="1">
                  <c:v>Controls IW</c:v>
                </c:pt>
                <c:pt idx="2">
                  <c:v>Art pts   NW</c:v>
                </c:pt>
                <c:pt idx="3">
                  <c:v>Art pts   IW</c:v>
                </c:pt>
                <c:pt idx="4">
                  <c:v>OA pts NW</c:v>
                </c:pt>
                <c:pt idx="5">
                  <c:v>OA pts   IW</c:v>
                </c:pt>
              </c:strCache>
            </c:strRef>
          </c:cat>
          <c:val>
            <c:numRef>
              <c:f>'[Chart in Microsoft PowerPoint]Graphs'!$N$105:$S$105</c:f>
              <c:numCache>
                <c:formatCode>General</c:formatCode>
                <c:ptCount val="6"/>
                <c:pt idx="0">
                  <c:v>434.87804878048769</c:v>
                </c:pt>
                <c:pt idx="1">
                  <c:v>448.39024390243901</c:v>
                </c:pt>
                <c:pt idx="2">
                  <c:v>368.19047619047615</c:v>
                </c:pt>
                <c:pt idx="3">
                  <c:v>381</c:v>
                </c:pt>
                <c:pt idx="4">
                  <c:v>280.99999999999994</c:v>
                </c:pt>
                <c:pt idx="5">
                  <c:v>278.3888888888888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19027264"/>
        <c:axId val="619037600"/>
      </c:barChart>
      <c:catAx>
        <c:axId val="61902726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b="1">
                <a:latin typeface="+mn-lt"/>
                <a:cs typeface="Times New Roman" panose="02020603050405020304" pitchFamily="18" charset="0"/>
              </a:defRPr>
            </a:pPr>
            <a:endParaRPr lang="en-US"/>
          </a:p>
        </c:txPr>
        <c:crossAx val="619037600"/>
        <c:crosses val="autoZero"/>
        <c:auto val="1"/>
        <c:lblAlgn val="ctr"/>
        <c:lblOffset val="100"/>
        <c:noMultiLvlLbl val="0"/>
      </c:catAx>
      <c:valAx>
        <c:axId val="61903760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txPr>
          <a:bodyPr/>
          <a:lstStyle/>
          <a:p>
            <a:pPr>
              <a:defRPr b="1">
                <a:latin typeface="+mn-lt"/>
                <a:cs typeface="Times New Roman" panose="02020603050405020304" pitchFamily="18" charset="0"/>
              </a:defRPr>
            </a:pPr>
            <a:endParaRPr lang="en-US"/>
          </a:p>
        </c:txPr>
        <c:crossAx val="61902726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C5090E-D501-4860-8DAF-E6E566B376BC}" type="datetimeFigureOut">
              <a:rPr lang="en-US" smtClean="0"/>
              <a:t>15-Apr-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17575" y="744538"/>
            <a:ext cx="49625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16463"/>
            <a:ext cx="5438775" cy="44672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855AFD0-2907-4FD7-8400-3D3D028308A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05530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855AFD0-2907-4FD7-8400-3D3D028308A7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123160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855AFD0-2907-4FD7-8400-3D3D028308A7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1942487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855AFD0-2907-4FD7-8400-3D3D028308A7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740880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9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68897-0EB2-48B3-A8D9-3059CEFE896F}" type="datetimeFigureOut">
              <a:rPr lang="en-US" smtClean="0"/>
              <a:t>15-Apr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F8D57-06A4-4EE5-A9CF-37B021CE70E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68897-0EB2-48B3-A8D9-3059CEFE896F}" type="datetimeFigureOut">
              <a:rPr lang="en-US" smtClean="0"/>
              <a:t>15-Apr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F8D57-06A4-4EE5-A9CF-37B021CE70E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49" y="366713"/>
            <a:ext cx="1543051" cy="78009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5" y="366713"/>
            <a:ext cx="4476751" cy="78009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68897-0EB2-48B3-A8D9-3059CEFE896F}" type="datetimeFigureOut">
              <a:rPr lang="en-US" smtClean="0"/>
              <a:t>15-Apr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F8D57-06A4-4EE5-A9CF-37B021CE70E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68897-0EB2-48B3-A8D9-3059CEFE896F}" type="datetimeFigureOut">
              <a:rPr lang="en-US" smtClean="0"/>
              <a:t>15-Apr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F8D57-06A4-4EE5-A9CF-37B021CE70E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7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68897-0EB2-48B3-A8D9-3059CEFE896F}" type="datetimeFigureOut">
              <a:rPr lang="en-US" smtClean="0"/>
              <a:t>15-Apr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F8D57-06A4-4EE5-A9CF-37B021CE70E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3" y="2133601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3" y="2133601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68897-0EB2-48B3-A8D9-3059CEFE896F}" type="datetimeFigureOut">
              <a:rPr lang="en-US" smtClean="0"/>
              <a:t>15-Apr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F8D57-06A4-4EE5-A9CF-37B021CE70E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3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3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30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30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68897-0EB2-48B3-A8D9-3059CEFE896F}" type="datetimeFigureOut">
              <a:rPr lang="en-US" smtClean="0"/>
              <a:t>15-Apr-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F8D57-06A4-4EE5-A9CF-37B021CE70E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68897-0EB2-48B3-A8D9-3059CEFE896F}" type="datetimeFigureOut">
              <a:rPr lang="en-US" smtClean="0"/>
              <a:t>15-Apr-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F8D57-06A4-4EE5-A9CF-37B021CE70E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68897-0EB2-48B3-A8D9-3059CEFE896F}" type="datetimeFigureOut">
              <a:rPr lang="en-US" smtClean="0"/>
              <a:t>15-Apr-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F8D57-06A4-4EE5-A9CF-37B021CE70E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5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4" y="273054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5" y="1435104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68897-0EB2-48B3-A8D9-3059CEFE896F}" type="datetimeFigureOut">
              <a:rPr lang="en-US" smtClean="0"/>
              <a:t>15-Apr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F8D57-06A4-4EE5-A9CF-37B021CE70E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468897-0EB2-48B3-A8D9-3059CEFE896F}" type="datetimeFigureOut">
              <a:rPr lang="en-US" smtClean="0"/>
              <a:t>15-Apr-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EF8D57-06A4-4EE5-A9CF-37B021CE70E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 bwMode="gray"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4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468897-0EB2-48B3-A8D9-3059CEFE896F}" type="datetimeFigureOut">
              <a:rPr lang="en-US" smtClean="0"/>
              <a:t>15-Apr-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4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4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EF8D57-06A4-4EE5-A9CF-37B021CE70E2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simple.futarmal@odont.au.dk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533400" y="152400"/>
            <a:ext cx="8763000" cy="71250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endParaRPr lang="en-GB" sz="1200" b="1" dirty="0" smtClean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GB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 figures</a:t>
            </a:r>
            <a:r>
              <a:rPr lang="en-GB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GB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</a:t>
            </a:r>
            <a:r>
              <a:rPr lang="en-GB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          </a:t>
            </a:r>
            <a:r>
              <a:rPr lang="en-GB" sz="14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ain </a:t>
            </a:r>
            <a:r>
              <a:rPr lang="en-GB" sz="14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ofiling of patients with temporomandibular joint   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GB" sz="14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</a:t>
            </a:r>
            <a:r>
              <a:rPr lang="en-GB" sz="14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arthralgia </a:t>
            </a:r>
            <a:r>
              <a:rPr lang="en-GB" sz="14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osteoarthritis diagnosed with different imaging techniques 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GB" sz="14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 </a:t>
            </a:r>
            <a:r>
              <a:rPr lang="en-GB" sz="14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      </a:t>
            </a:r>
            <a:r>
              <a:rPr lang="en-US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mple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utarmal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Kothari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,2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Lene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Baad-Hansen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,2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Lars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olvig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Hansen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Niels Bang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   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</a:t>
            </a:r>
            <a:r>
              <a:rPr lang="en-US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                                        Leif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ovgaard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ørensen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lle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ulf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Eskildsen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Peter Svensson</a:t>
            </a:r>
            <a:r>
              <a:rPr lang="en-US" sz="12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,2,5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da-DK" sz="1200" baseline="30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GB" sz="1200" baseline="300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GB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ction 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 Orofacial Pain and Jaw Function, Institute of Odontology and Oral Health, Aarhus University, Denmark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GB" sz="1200" baseline="300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solidFill>
                  <a:srgbClr val="222222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candinavian Center for Orofacial Neurosciences (SCON)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GB" sz="1200" baseline="300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solidFill>
                  <a:srgbClr val="222222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artment of Radiology, Aarhus University Hospital, Denmark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GB" sz="1200" baseline="300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200" dirty="0">
                <a:solidFill>
                  <a:srgbClr val="222222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artment of Neuroradiology, Aarhus University Hospital, Denmark 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GB" sz="1200" baseline="300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sz="1200" dirty="0">
                <a:solidFill>
                  <a:srgbClr val="222222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artment of Dental Medicine, </a:t>
            </a:r>
            <a:r>
              <a:rPr lang="en-US" sz="1200" dirty="0" err="1">
                <a:solidFill>
                  <a:srgbClr val="222222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arolinska</a:t>
            </a:r>
            <a:r>
              <a:rPr lang="en-US" sz="1200" dirty="0">
                <a:solidFill>
                  <a:srgbClr val="222222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 err="1">
                <a:solidFill>
                  <a:srgbClr val="222222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stitutet</a:t>
            </a:r>
            <a:r>
              <a:rPr lang="en-US" sz="1200" dirty="0">
                <a:solidFill>
                  <a:srgbClr val="222222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Huddinge, Sweden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sz="1200" dirty="0">
                <a:solidFill>
                  <a:srgbClr val="222222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r>
              <a:rPr lang="en-GB" sz="1200" b="1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rresponding </a:t>
            </a:r>
            <a:r>
              <a:rPr lang="en-GB" sz="12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uthor: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imple </a:t>
            </a:r>
            <a:r>
              <a:rPr lang="en-GB" sz="12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utarmal</a:t>
            </a: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Kothari, BDS, PhD student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ction of Orofacial Pain and Jaw Function 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nstitute of Odontology and Oral Health, Aarhus University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da-DK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ennelyst Boulevard 9 </a:t>
            </a:r>
            <a:r>
              <a:rPr lang="en-US" sz="1100" dirty="0" smtClean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da-DK" sz="1200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nmark-8000</a:t>
            </a:r>
            <a:r>
              <a:rPr lang="da-DK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Aarhus C, Denmark. 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mail: </a:t>
            </a:r>
            <a:r>
              <a:rPr lang="en-US" sz="1200" u="sng" dirty="0">
                <a:solidFill>
                  <a:srgbClr val="0000FF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hlinkClick r:id="rId2"/>
              </a:rPr>
              <a:t>simple.futarmal@odont.au.dk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GB" sz="12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hone number: +45 5039 5697</a:t>
            </a:r>
            <a:endParaRPr lang="en-US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Bef>
                <a:spcPts val="1200"/>
              </a:spcBef>
            </a:pPr>
            <a:r>
              <a:rPr lang="en-GB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en-US" sz="11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4968088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Rectangle 37"/>
          <p:cNvSpPr/>
          <p:nvPr/>
        </p:nvSpPr>
        <p:spPr>
          <a:xfrm>
            <a:off x="7865732" y="1903589"/>
            <a:ext cx="1333051" cy="33994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n CBCT imaging</a:t>
            </a:r>
            <a:endParaRPr lang="en-US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35" name="Group 234"/>
          <p:cNvGrpSpPr/>
          <p:nvPr/>
        </p:nvGrpSpPr>
        <p:grpSpPr>
          <a:xfrm>
            <a:off x="524232" y="2630826"/>
            <a:ext cx="1514401" cy="1027545"/>
            <a:chOff x="277246" y="2596079"/>
            <a:chExt cx="1514401" cy="1027545"/>
          </a:xfrm>
        </p:grpSpPr>
        <p:sp>
          <p:nvSpPr>
            <p:cNvPr id="162" name="Rectangle 161"/>
            <p:cNvSpPr/>
            <p:nvPr/>
          </p:nvSpPr>
          <p:spPr>
            <a:xfrm>
              <a:off x="515014" y="2596079"/>
              <a:ext cx="1010860" cy="25717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J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2" name="Rectangle 221"/>
            <p:cNvSpPr/>
            <p:nvPr/>
          </p:nvSpPr>
          <p:spPr>
            <a:xfrm>
              <a:off x="277246" y="3392155"/>
              <a:ext cx="338328" cy="22288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8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34" name="Group 233"/>
            <p:cNvGrpSpPr/>
            <p:nvPr/>
          </p:nvGrpSpPr>
          <p:grpSpPr>
            <a:xfrm>
              <a:off x="471887" y="2876432"/>
              <a:ext cx="1319760" cy="747192"/>
              <a:chOff x="471887" y="2876432"/>
              <a:chExt cx="1319760" cy="747192"/>
            </a:xfrm>
          </p:grpSpPr>
          <p:cxnSp>
            <p:nvCxnSpPr>
              <p:cNvPr id="165" name="Elbow Connector 164"/>
              <p:cNvCxnSpPr/>
              <p:nvPr/>
            </p:nvCxnSpPr>
            <p:spPr>
              <a:xfrm rot="16200000" flipV="1">
                <a:off x="1067213" y="2865374"/>
                <a:ext cx="342900" cy="365760"/>
              </a:xfrm>
              <a:prstGeom prst="bentConnector3">
                <a:avLst>
                  <a:gd name="adj1" fmla="val 50000"/>
                </a:avLst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6" name="Elbow Connector 165"/>
              <p:cNvCxnSpPr/>
              <p:nvPr/>
            </p:nvCxnSpPr>
            <p:spPr>
              <a:xfrm rot="5400000" flipH="1" flipV="1">
                <a:off x="697230" y="2865002"/>
                <a:ext cx="342900" cy="365760"/>
              </a:xfrm>
              <a:prstGeom prst="bentConnector3">
                <a:avLst>
                  <a:gd name="adj1" fmla="val 50000"/>
                </a:avLst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0" name="Rectangle 199"/>
              <p:cNvSpPr/>
              <p:nvPr/>
            </p:nvSpPr>
            <p:spPr>
              <a:xfrm>
                <a:off x="664134" y="3392155"/>
                <a:ext cx="338328" cy="22288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</a:p>
            </p:txBody>
          </p:sp>
          <p:sp>
            <p:nvSpPr>
              <p:cNvPr id="220" name="Rectangle 219"/>
              <p:cNvSpPr/>
              <p:nvPr/>
            </p:nvSpPr>
            <p:spPr>
              <a:xfrm>
                <a:off x="1063221" y="3399968"/>
                <a:ext cx="338328" cy="22288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</a:t>
                </a:r>
                <a:endParaRPr lang="en-US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3" name="Rectangle 222"/>
              <p:cNvSpPr/>
              <p:nvPr/>
            </p:nvSpPr>
            <p:spPr>
              <a:xfrm>
                <a:off x="1453319" y="3400739"/>
                <a:ext cx="338328" cy="22288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</a:p>
            </p:txBody>
          </p:sp>
          <p:cxnSp>
            <p:nvCxnSpPr>
              <p:cNvPr id="28" name="Straight Connector 27"/>
              <p:cNvCxnSpPr/>
              <p:nvPr/>
            </p:nvCxnSpPr>
            <p:spPr>
              <a:xfrm>
                <a:off x="471887" y="3213228"/>
                <a:ext cx="36576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/>
              <p:cNvCxnSpPr/>
              <p:nvPr/>
            </p:nvCxnSpPr>
            <p:spPr>
              <a:xfrm>
                <a:off x="476068" y="3215720"/>
                <a:ext cx="0" cy="16035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7" name="Straight Connector 226"/>
              <p:cNvCxnSpPr/>
              <p:nvPr/>
            </p:nvCxnSpPr>
            <p:spPr>
              <a:xfrm>
                <a:off x="828336" y="3216909"/>
                <a:ext cx="0" cy="16035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0" name="Straight Connector 229"/>
              <p:cNvCxnSpPr/>
              <p:nvPr/>
            </p:nvCxnSpPr>
            <p:spPr>
              <a:xfrm>
                <a:off x="1249679" y="3230349"/>
                <a:ext cx="36576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1" name="Straight Connector 230"/>
              <p:cNvCxnSpPr/>
              <p:nvPr/>
            </p:nvCxnSpPr>
            <p:spPr>
              <a:xfrm>
                <a:off x="1251474" y="3222175"/>
                <a:ext cx="0" cy="16035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2" name="Straight Connector 231"/>
              <p:cNvCxnSpPr/>
              <p:nvPr/>
            </p:nvCxnSpPr>
            <p:spPr>
              <a:xfrm>
                <a:off x="1617760" y="3224066"/>
                <a:ext cx="0" cy="160351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48" name="Group 247"/>
          <p:cNvGrpSpPr/>
          <p:nvPr/>
        </p:nvGrpSpPr>
        <p:grpSpPr>
          <a:xfrm>
            <a:off x="6670950" y="4073826"/>
            <a:ext cx="2959625" cy="2746268"/>
            <a:chOff x="2848544" y="4070874"/>
            <a:chExt cx="2959625" cy="2746268"/>
          </a:xfrm>
        </p:grpSpPr>
        <p:sp>
          <p:nvSpPr>
            <p:cNvPr id="249" name="Rectangle 248"/>
            <p:cNvSpPr/>
            <p:nvPr/>
          </p:nvSpPr>
          <p:spPr>
            <a:xfrm>
              <a:off x="2848544" y="4537632"/>
              <a:ext cx="1177650" cy="33994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n MRI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0" name="Rectangle 249"/>
            <p:cNvSpPr/>
            <p:nvPr/>
          </p:nvSpPr>
          <p:spPr>
            <a:xfrm>
              <a:off x="4081272" y="4070874"/>
              <a:ext cx="338328" cy="22288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0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51" name="Elbow Connector 250"/>
            <p:cNvCxnSpPr/>
            <p:nvPr/>
          </p:nvCxnSpPr>
          <p:spPr>
            <a:xfrm rot="16200000" flipV="1">
              <a:off x="4374143" y="4351207"/>
              <a:ext cx="365760" cy="548640"/>
            </a:xfrm>
            <a:prstGeom prst="bentConnector3">
              <a:avLst>
                <a:gd name="adj1" fmla="val 50000"/>
              </a:avLst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2" name="Elbow Connector 251"/>
            <p:cNvCxnSpPr/>
            <p:nvPr/>
          </p:nvCxnSpPr>
          <p:spPr>
            <a:xfrm rot="5400000" flipH="1" flipV="1">
              <a:off x="3827536" y="4351207"/>
              <a:ext cx="365760" cy="548640"/>
            </a:xfrm>
            <a:prstGeom prst="bentConnector3">
              <a:avLst>
                <a:gd name="adj1" fmla="val 50000"/>
              </a:avLst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3" name="Elbow Connector 252"/>
            <p:cNvCxnSpPr/>
            <p:nvPr/>
          </p:nvCxnSpPr>
          <p:spPr>
            <a:xfrm rot="5400000" flipH="1" flipV="1">
              <a:off x="3469619" y="4692323"/>
              <a:ext cx="253746" cy="295027"/>
            </a:xfrm>
            <a:prstGeom prst="bentConnector3">
              <a:avLst>
                <a:gd name="adj1" fmla="val 50000"/>
              </a:avLst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4" name="Elbow Connector 253"/>
            <p:cNvCxnSpPr/>
            <p:nvPr/>
          </p:nvCxnSpPr>
          <p:spPr>
            <a:xfrm rot="16200000" flipV="1">
              <a:off x="3754254" y="4692759"/>
              <a:ext cx="252513" cy="297299"/>
            </a:xfrm>
            <a:prstGeom prst="bentConnector3">
              <a:avLst>
                <a:gd name="adj1" fmla="val 50000"/>
              </a:avLst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5" name="Elbow Connector 254"/>
            <p:cNvCxnSpPr/>
            <p:nvPr/>
          </p:nvCxnSpPr>
          <p:spPr>
            <a:xfrm rot="16200000" flipV="1">
              <a:off x="4844505" y="4701788"/>
              <a:ext cx="252513" cy="292608"/>
            </a:xfrm>
            <a:prstGeom prst="bentConnector3">
              <a:avLst>
                <a:gd name="adj1" fmla="val 50000"/>
              </a:avLst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6" name="Elbow Connector 255"/>
            <p:cNvCxnSpPr/>
            <p:nvPr/>
          </p:nvCxnSpPr>
          <p:spPr>
            <a:xfrm rot="5400000" flipH="1" flipV="1">
              <a:off x="4557750" y="4698407"/>
              <a:ext cx="253746" cy="295027"/>
            </a:xfrm>
            <a:prstGeom prst="bentConnector3">
              <a:avLst>
                <a:gd name="adj1" fmla="val 50000"/>
              </a:avLst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7" name="Rectangle 256"/>
            <p:cNvSpPr/>
            <p:nvPr/>
          </p:nvSpPr>
          <p:spPr>
            <a:xfrm>
              <a:off x="2938953" y="5189120"/>
              <a:ext cx="963951" cy="25717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rt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8" name="Rectangle 257"/>
            <p:cNvSpPr/>
            <p:nvPr/>
          </p:nvSpPr>
          <p:spPr>
            <a:xfrm>
              <a:off x="4341813" y="4550885"/>
              <a:ext cx="1466356" cy="33994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n US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9" name="Rectangle 258"/>
            <p:cNvSpPr/>
            <p:nvPr/>
          </p:nvSpPr>
          <p:spPr>
            <a:xfrm>
              <a:off x="4944335" y="4979960"/>
              <a:ext cx="338328" cy="22288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8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0" name="Rectangle 259"/>
            <p:cNvSpPr/>
            <p:nvPr/>
          </p:nvSpPr>
          <p:spPr>
            <a:xfrm>
              <a:off x="4350408" y="4985006"/>
              <a:ext cx="338328" cy="22288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2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1" name="Rectangle 260"/>
            <p:cNvSpPr/>
            <p:nvPr/>
          </p:nvSpPr>
          <p:spPr>
            <a:xfrm>
              <a:off x="3821345" y="4978487"/>
              <a:ext cx="374904" cy="21945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r>
                <a:rPr lang="en-US" sz="1100" baseline="300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2" name="Rectangle 261"/>
            <p:cNvSpPr/>
            <p:nvPr/>
          </p:nvSpPr>
          <p:spPr>
            <a:xfrm>
              <a:off x="3239507" y="4980965"/>
              <a:ext cx="338328" cy="22288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5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3" name="Rectangle 262"/>
            <p:cNvSpPr/>
            <p:nvPr/>
          </p:nvSpPr>
          <p:spPr>
            <a:xfrm>
              <a:off x="4011592" y="5191997"/>
              <a:ext cx="963951" cy="25717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rt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4" name="Rectangle 263"/>
            <p:cNvSpPr/>
            <p:nvPr/>
          </p:nvSpPr>
          <p:spPr>
            <a:xfrm>
              <a:off x="4522094" y="5194076"/>
              <a:ext cx="1188405" cy="25717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A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5" name="Rectangle 264"/>
            <p:cNvSpPr/>
            <p:nvPr/>
          </p:nvSpPr>
          <p:spPr>
            <a:xfrm>
              <a:off x="3411270" y="5194076"/>
              <a:ext cx="1188405" cy="25717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A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66" name="Straight Connector 265"/>
            <p:cNvCxnSpPr/>
            <p:nvPr/>
          </p:nvCxnSpPr>
          <p:spPr>
            <a:xfrm>
              <a:off x="4282944" y="4501813"/>
              <a:ext cx="1" cy="164592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8" name="Rectangle 267"/>
            <p:cNvSpPr/>
            <p:nvPr/>
          </p:nvSpPr>
          <p:spPr>
            <a:xfrm>
              <a:off x="3421106" y="6300501"/>
              <a:ext cx="338328" cy="22288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4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4" name="Rectangle 273"/>
            <p:cNvSpPr/>
            <p:nvPr/>
          </p:nvSpPr>
          <p:spPr>
            <a:xfrm>
              <a:off x="3105466" y="6559967"/>
              <a:ext cx="963951" cy="25717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RI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US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75" name="Group 274"/>
            <p:cNvGrpSpPr/>
            <p:nvPr/>
          </p:nvGrpSpPr>
          <p:grpSpPr>
            <a:xfrm>
              <a:off x="3565819" y="6134557"/>
              <a:ext cx="1843978" cy="680666"/>
              <a:chOff x="835000" y="8146425"/>
              <a:chExt cx="1886018" cy="907555"/>
            </a:xfrm>
          </p:grpSpPr>
          <p:cxnSp>
            <p:nvCxnSpPr>
              <p:cNvPr id="276" name="Straight Connector 275"/>
              <p:cNvCxnSpPr/>
              <p:nvPr/>
            </p:nvCxnSpPr>
            <p:spPr>
              <a:xfrm>
                <a:off x="844766" y="8157654"/>
                <a:ext cx="1409554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7" name="Rectangle 276"/>
              <p:cNvSpPr/>
              <p:nvPr/>
            </p:nvSpPr>
            <p:spPr>
              <a:xfrm>
                <a:off x="1148325" y="8378190"/>
                <a:ext cx="364541" cy="29718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</a:t>
                </a:r>
                <a:endPara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8" name="Rectangle 277"/>
              <p:cNvSpPr/>
              <p:nvPr/>
            </p:nvSpPr>
            <p:spPr>
              <a:xfrm>
                <a:off x="1606140" y="8362425"/>
                <a:ext cx="346041" cy="29718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</a:t>
                </a:r>
                <a:endPara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9" name="Rectangle 278"/>
              <p:cNvSpPr/>
              <p:nvPr/>
            </p:nvSpPr>
            <p:spPr>
              <a:xfrm>
                <a:off x="2050429" y="8367680"/>
                <a:ext cx="346041" cy="29718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</a:p>
            </p:txBody>
          </p:sp>
          <p:cxnSp>
            <p:nvCxnSpPr>
              <p:cNvPr id="280" name="Straight Connector 279"/>
              <p:cNvCxnSpPr/>
              <p:nvPr/>
            </p:nvCxnSpPr>
            <p:spPr>
              <a:xfrm>
                <a:off x="856149" y="8153400"/>
                <a:ext cx="0" cy="21600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1" name="Straight Connector 280"/>
              <p:cNvCxnSpPr/>
              <p:nvPr/>
            </p:nvCxnSpPr>
            <p:spPr>
              <a:xfrm>
                <a:off x="1329560" y="8153400"/>
                <a:ext cx="0" cy="21600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2" name="Straight Connector 281"/>
              <p:cNvCxnSpPr/>
              <p:nvPr/>
            </p:nvCxnSpPr>
            <p:spPr>
              <a:xfrm>
                <a:off x="1798119" y="8146425"/>
                <a:ext cx="0" cy="21600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3" name="Straight Connector 282"/>
              <p:cNvCxnSpPr/>
              <p:nvPr/>
            </p:nvCxnSpPr>
            <p:spPr>
              <a:xfrm>
                <a:off x="2245904" y="8151678"/>
                <a:ext cx="0" cy="21600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4" name="Rectangle 283"/>
              <p:cNvSpPr/>
              <p:nvPr/>
            </p:nvSpPr>
            <p:spPr>
              <a:xfrm>
                <a:off x="835000" y="8711080"/>
                <a:ext cx="985927" cy="3429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r>
                  <a:rPr lang="en-US" sz="11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RI</a:t>
                </a:r>
                <a:endPara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en-US" sz="11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r>
                  <a:rPr lang="en-US" sz="11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S</a:t>
                </a:r>
                <a:endPara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5" name="Rectangle 284"/>
              <p:cNvSpPr/>
              <p:nvPr/>
            </p:nvSpPr>
            <p:spPr>
              <a:xfrm>
                <a:off x="1311809" y="8706923"/>
                <a:ext cx="985927" cy="3429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r>
                  <a:rPr lang="en-US" sz="11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RI</a:t>
                </a:r>
                <a:endPara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en-US" sz="11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r>
                  <a:rPr lang="en-US" sz="11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S</a:t>
                </a:r>
                <a:endPara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6" name="Rectangle 285"/>
              <p:cNvSpPr/>
              <p:nvPr/>
            </p:nvSpPr>
            <p:spPr>
              <a:xfrm>
                <a:off x="1735091" y="8709313"/>
                <a:ext cx="985927" cy="342900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r>
                  <a:rPr lang="en-US" sz="11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RI</a:t>
                </a:r>
                <a:endPara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en-US" sz="11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US</a:t>
                </a:r>
                <a:endPara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290" name="Rectangle 289"/>
          <p:cNvSpPr/>
          <p:nvPr/>
        </p:nvSpPr>
        <p:spPr>
          <a:xfrm>
            <a:off x="310243" y="2984726"/>
            <a:ext cx="684067" cy="33994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n MRI</a:t>
            </a:r>
            <a:endParaRPr lang="en-US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5" name="Rectangle 294"/>
          <p:cNvSpPr/>
          <p:nvPr/>
        </p:nvSpPr>
        <p:spPr>
          <a:xfrm>
            <a:off x="508258" y="3629234"/>
            <a:ext cx="354303" cy="257175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</a:t>
            </a:r>
            <a:r>
              <a:rPr lang="en-US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J</a:t>
            </a:r>
            <a:endParaRPr lang="en-US" sz="11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836494" y="59960"/>
            <a:ext cx="7932266" cy="6766291"/>
            <a:chOff x="826969" y="59960"/>
            <a:chExt cx="7932266" cy="6766291"/>
          </a:xfrm>
        </p:grpSpPr>
        <p:sp>
          <p:nvSpPr>
            <p:cNvPr id="41" name="Rectangle 40"/>
            <p:cNvSpPr/>
            <p:nvPr/>
          </p:nvSpPr>
          <p:spPr>
            <a:xfrm>
              <a:off x="2653808" y="1920170"/>
              <a:ext cx="1333051" cy="33994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n CBCT imaging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Rectangle 3"/>
            <p:cNvSpPr/>
            <p:nvPr/>
          </p:nvSpPr>
          <p:spPr>
            <a:xfrm>
              <a:off x="4161366" y="59960"/>
              <a:ext cx="1714831" cy="4829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umber of Joints</a:t>
              </a:r>
            </a:p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16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" name="Straight Connector 5"/>
            <p:cNvCxnSpPr/>
            <p:nvPr/>
          </p:nvCxnSpPr>
          <p:spPr>
            <a:xfrm>
              <a:off x="5014501" y="533160"/>
              <a:ext cx="0" cy="82296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>
              <a:off x="4262398" y="2880731"/>
              <a:ext cx="1" cy="118872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Rectangle 32"/>
            <p:cNvSpPr/>
            <p:nvPr/>
          </p:nvSpPr>
          <p:spPr>
            <a:xfrm>
              <a:off x="4849728" y="1545776"/>
              <a:ext cx="338328" cy="22288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</a:t>
              </a:r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Rectangle 16"/>
            <p:cNvSpPr/>
            <p:nvPr/>
          </p:nvSpPr>
          <p:spPr>
            <a:xfrm>
              <a:off x="5935284" y="746133"/>
              <a:ext cx="2207100" cy="33994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n RDC/TMD clinical examination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1" name="Elbow Connector 20"/>
            <p:cNvCxnSpPr/>
            <p:nvPr/>
          </p:nvCxnSpPr>
          <p:spPr>
            <a:xfrm rot="5400000" flipH="1" flipV="1">
              <a:off x="4437018" y="1813380"/>
              <a:ext cx="411480" cy="795528"/>
            </a:xfrm>
            <a:prstGeom prst="bentConnector3">
              <a:avLst>
                <a:gd name="adj1" fmla="val 50000"/>
              </a:avLst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Elbow Connector 21"/>
            <p:cNvCxnSpPr/>
            <p:nvPr/>
          </p:nvCxnSpPr>
          <p:spPr>
            <a:xfrm rot="16200000" flipV="1">
              <a:off x="5240274" y="1822011"/>
              <a:ext cx="411480" cy="795528"/>
            </a:xfrm>
            <a:prstGeom prst="bentConnector3">
              <a:avLst>
                <a:gd name="adj1" fmla="val 50000"/>
              </a:avLst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Elbow Connector 63"/>
            <p:cNvCxnSpPr/>
            <p:nvPr/>
          </p:nvCxnSpPr>
          <p:spPr>
            <a:xfrm rot="16200000" flipV="1">
              <a:off x="7507224" y="1804410"/>
              <a:ext cx="411480" cy="795528"/>
            </a:xfrm>
            <a:prstGeom prst="bentConnector3">
              <a:avLst>
                <a:gd name="adj1" fmla="val 50000"/>
              </a:avLst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Elbow Connector 72"/>
            <p:cNvCxnSpPr/>
            <p:nvPr/>
          </p:nvCxnSpPr>
          <p:spPr>
            <a:xfrm rot="5400000" flipH="1" flipV="1">
              <a:off x="6711623" y="1807031"/>
              <a:ext cx="411480" cy="795676"/>
            </a:xfrm>
            <a:prstGeom prst="bentConnector3">
              <a:avLst>
                <a:gd name="adj1" fmla="val 50000"/>
              </a:avLst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Rectangle 68"/>
            <p:cNvSpPr/>
            <p:nvPr/>
          </p:nvSpPr>
          <p:spPr>
            <a:xfrm>
              <a:off x="4572002" y="1725519"/>
              <a:ext cx="963951" cy="25717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rt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Rectangle 78"/>
            <p:cNvSpPr/>
            <p:nvPr/>
          </p:nvSpPr>
          <p:spPr>
            <a:xfrm>
              <a:off x="7140391" y="1563565"/>
              <a:ext cx="338328" cy="22288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</a:t>
              </a:r>
            </a:p>
          </p:txBody>
        </p:sp>
        <p:sp>
          <p:nvSpPr>
            <p:cNvPr id="80" name="Rectangle 79"/>
            <p:cNvSpPr/>
            <p:nvPr/>
          </p:nvSpPr>
          <p:spPr>
            <a:xfrm>
              <a:off x="6744195" y="1746436"/>
              <a:ext cx="1188405" cy="25717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A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Rectangle 80"/>
            <p:cNvSpPr/>
            <p:nvPr/>
          </p:nvSpPr>
          <p:spPr>
            <a:xfrm>
              <a:off x="5662976" y="2411241"/>
              <a:ext cx="338328" cy="22288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0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Rectangle 81"/>
            <p:cNvSpPr/>
            <p:nvPr/>
          </p:nvSpPr>
          <p:spPr>
            <a:xfrm>
              <a:off x="4070515" y="2415947"/>
              <a:ext cx="338328" cy="21945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3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Rectangle 82"/>
            <p:cNvSpPr/>
            <p:nvPr/>
          </p:nvSpPr>
          <p:spPr>
            <a:xfrm>
              <a:off x="6344515" y="2405492"/>
              <a:ext cx="338328" cy="22288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8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Rectangle 83"/>
            <p:cNvSpPr/>
            <p:nvPr/>
          </p:nvSpPr>
          <p:spPr>
            <a:xfrm>
              <a:off x="7943455" y="2406531"/>
              <a:ext cx="338328" cy="22288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Rectangle 84"/>
            <p:cNvSpPr/>
            <p:nvPr/>
          </p:nvSpPr>
          <p:spPr>
            <a:xfrm>
              <a:off x="6019802" y="2623593"/>
              <a:ext cx="963951" cy="25717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rt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Rectangle 85"/>
            <p:cNvSpPr/>
            <p:nvPr/>
          </p:nvSpPr>
          <p:spPr>
            <a:xfrm>
              <a:off x="5257800" y="2619123"/>
              <a:ext cx="1188405" cy="25717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A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Rectangle 86"/>
            <p:cNvSpPr/>
            <p:nvPr/>
          </p:nvSpPr>
          <p:spPr>
            <a:xfrm>
              <a:off x="3755836" y="2630711"/>
              <a:ext cx="963951" cy="25717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rt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Rectangle 87"/>
            <p:cNvSpPr/>
            <p:nvPr/>
          </p:nvSpPr>
          <p:spPr>
            <a:xfrm>
              <a:off x="7519072" y="2621063"/>
              <a:ext cx="1188405" cy="25717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A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9" name="Straight Connector 88"/>
            <p:cNvCxnSpPr/>
            <p:nvPr/>
          </p:nvCxnSpPr>
          <p:spPr>
            <a:xfrm>
              <a:off x="8099235" y="2875003"/>
              <a:ext cx="1" cy="118872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0" name="Straight Connector 89"/>
            <p:cNvCxnSpPr>
              <a:stCxn id="85" idx="2"/>
            </p:cNvCxnSpPr>
            <p:nvPr/>
          </p:nvCxnSpPr>
          <p:spPr>
            <a:xfrm flipH="1">
              <a:off x="4267200" y="2880768"/>
              <a:ext cx="2234576" cy="1196901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Straight Connector 90"/>
            <p:cNvCxnSpPr/>
            <p:nvPr/>
          </p:nvCxnSpPr>
          <p:spPr>
            <a:xfrm>
              <a:off x="5976768" y="2855728"/>
              <a:ext cx="2119136" cy="1211559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" name="Group 1"/>
            <p:cNvGrpSpPr/>
            <p:nvPr/>
          </p:nvGrpSpPr>
          <p:grpSpPr>
            <a:xfrm>
              <a:off x="2828678" y="4070874"/>
              <a:ext cx="2890807" cy="2755377"/>
              <a:chOff x="2828676" y="4070874"/>
              <a:chExt cx="2890807" cy="2755377"/>
            </a:xfrm>
          </p:grpSpPr>
          <p:sp>
            <p:nvSpPr>
              <p:cNvPr id="59" name="Rectangle 58"/>
              <p:cNvSpPr/>
              <p:nvPr/>
            </p:nvSpPr>
            <p:spPr>
              <a:xfrm>
                <a:off x="2828676" y="4548649"/>
                <a:ext cx="1177650" cy="33994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n MRI</a:t>
                </a:r>
                <a:endPara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2" name="Rectangle 91"/>
              <p:cNvSpPr/>
              <p:nvPr/>
            </p:nvSpPr>
            <p:spPr>
              <a:xfrm>
                <a:off x="4081272" y="4070874"/>
                <a:ext cx="338328" cy="22288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1</a:t>
                </a:r>
                <a:endPara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96" name="Elbow Connector 95"/>
              <p:cNvCxnSpPr/>
              <p:nvPr/>
            </p:nvCxnSpPr>
            <p:spPr>
              <a:xfrm rot="16200000" flipV="1">
                <a:off x="4352634" y="4355418"/>
                <a:ext cx="365760" cy="548640"/>
              </a:xfrm>
              <a:prstGeom prst="bentConnector3">
                <a:avLst>
                  <a:gd name="adj1" fmla="val 50000"/>
                </a:avLst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Elbow Connector 98"/>
              <p:cNvCxnSpPr/>
              <p:nvPr/>
            </p:nvCxnSpPr>
            <p:spPr>
              <a:xfrm rot="5400000" flipH="1" flipV="1">
                <a:off x="3805243" y="4354194"/>
                <a:ext cx="365760" cy="548640"/>
              </a:xfrm>
              <a:prstGeom prst="bentConnector3">
                <a:avLst>
                  <a:gd name="adj1" fmla="val 50000"/>
                </a:avLst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Elbow Connector 99"/>
              <p:cNvCxnSpPr/>
              <p:nvPr/>
            </p:nvCxnSpPr>
            <p:spPr>
              <a:xfrm rot="5400000" flipH="1" flipV="1">
                <a:off x="3438319" y="4697984"/>
                <a:ext cx="253746" cy="295027"/>
              </a:xfrm>
              <a:prstGeom prst="bentConnector3">
                <a:avLst>
                  <a:gd name="adj1" fmla="val 50000"/>
                </a:avLst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Elbow Connector 101"/>
              <p:cNvCxnSpPr/>
              <p:nvPr/>
            </p:nvCxnSpPr>
            <p:spPr>
              <a:xfrm rot="16200000" flipV="1">
                <a:off x="3736703" y="4693443"/>
                <a:ext cx="252513" cy="297299"/>
              </a:xfrm>
              <a:prstGeom prst="bentConnector3">
                <a:avLst>
                  <a:gd name="adj1" fmla="val 50000"/>
                </a:avLst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4" name="Elbow Connector 103"/>
              <p:cNvCxnSpPr/>
              <p:nvPr/>
            </p:nvCxnSpPr>
            <p:spPr>
              <a:xfrm rot="16200000" flipV="1">
                <a:off x="4826135" y="4690091"/>
                <a:ext cx="252513" cy="292608"/>
              </a:xfrm>
              <a:prstGeom prst="bentConnector3">
                <a:avLst>
                  <a:gd name="adj1" fmla="val 50000"/>
                </a:avLst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Elbow Connector 111"/>
              <p:cNvCxnSpPr/>
              <p:nvPr/>
            </p:nvCxnSpPr>
            <p:spPr>
              <a:xfrm rot="5400000" flipH="1" flipV="1">
                <a:off x="4527818" y="4693924"/>
                <a:ext cx="253746" cy="295027"/>
              </a:xfrm>
              <a:prstGeom prst="bentConnector3">
                <a:avLst>
                  <a:gd name="adj1" fmla="val 50000"/>
                </a:avLst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3" name="Rectangle 112"/>
              <p:cNvSpPr/>
              <p:nvPr/>
            </p:nvSpPr>
            <p:spPr>
              <a:xfrm>
                <a:off x="2938953" y="5189120"/>
                <a:ext cx="963951" cy="25717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rt</a:t>
                </a:r>
                <a:endPara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8" name="Rectangle 57"/>
              <p:cNvSpPr/>
              <p:nvPr/>
            </p:nvSpPr>
            <p:spPr>
              <a:xfrm>
                <a:off x="4386432" y="4550885"/>
                <a:ext cx="1333051" cy="33994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n US</a:t>
                </a:r>
                <a:endPara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Rectangle 61"/>
              <p:cNvSpPr/>
              <p:nvPr/>
            </p:nvSpPr>
            <p:spPr>
              <a:xfrm>
                <a:off x="4933318" y="4984253"/>
                <a:ext cx="338328" cy="22288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6</a:t>
                </a:r>
                <a:endPara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" name="Rectangle 65"/>
              <p:cNvSpPr/>
              <p:nvPr/>
            </p:nvSpPr>
            <p:spPr>
              <a:xfrm>
                <a:off x="4339391" y="4985006"/>
                <a:ext cx="338328" cy="22288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</a:t>
                </a:r>
                <a:endPara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" name="Rectangle 66"/>
              <p:cNvSpPr/>
              <p:nvPr/>
            </p:nvSpPr>
            <p:spPr>
              <a:xfrm>
                <a:off x="3832363" y="4978487"/>
                <a:ext cx="338328" cy="22288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</a:p>
            </p:txBody>
          </p:sp>
          <p:sp>
            <p:nvSpPr>
              <p:cNvPr id="68" name="Rectangle 67"/>
              <p:cNvSpPr/>
              <p:nvPr/>
            </p:nvSpPr>
            <p:spPr>
              <a:xfrm>
                <a:off x="3239507" y="4980965"/>
                <a:ext cx="338328" cy="22288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9</a:t>
                </a:r>
                <a:endPara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" name="Rectangle 70"/>
              <p:cNvSpPr/>
              <p:nvPr/>
            </p:nvSpPr>
            <p:spPr>
              <a:xfrm>
                <a:off x="4011592" y="5191997"/>
                <a:ext cx="963951" cy="25717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rt</a:t>
                </a:r>
                <a:endPara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Rectangle 75"/>
              <p:cNvSpPr/>
              <p:nvPr/>
            </p:nvSpPr>
            <p:spPr>
              <a:xfrm>
                <a:off x="4522094" y="5194076"/>
                <a:ext cx="1188405" cy="25717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A</a:t>
                </a:r>
                <a:endPara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" name="Rectangle 76"/>
              <p:cNvSpPr/>
              <p:nvPr/>
            </p:nvSpPr>
            <p:spPr>
              <a:xfrm>
                <a:off x="3411270" y="5194076"/>
                <a:ext cx="1188405" cy="25717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A</a:t>
                </a:r>
                <a:endPara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78" name="Straight Connector 77"/>
              <p:cNvCxnSpPr/>
              <p:nvPr/>
            </p:nvCxnSpPr>
            <p:spPr>
              <a:xfrm>
                <a:off x="4260910" y="4647726"/>
                <a:ext cx="1" cy="150876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9" name="Rectangle 118"/>
              <p:cNvSpPr/>
              <p:nvPr/>
            </p:nvSpPr>
            <p:spPr>
              <a:xfrm>
                <a:off x="3421106" y="6300501"/>
                <a:ext cx="338328" cy="22288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4</a:t>
                </a:r>
                <a:endPara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" name="Rectangle 125"/>
              <p:cNvSpPr/>
              <p:nvPr/>
            </p:nvSpPr>
            <p:spPr>
              <a:xfrm>
                <a:off x="3105466" y="6560485"/>
                <a:ext cx="963951" cy="25717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r>
                  <a:rPr lang="en-US" sz="11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RI</a:t>
                </a:r>
                <a:endPara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/>
                <a:r>
                  <a:rPr lang="en-US" sz="11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r>
                  <a:rPr lang="en-US" sz="1100" dirty="0" smtClean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S</a:t>
                </a:r>
                <a:endPara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7" name="Group 6"/>
              <p:cNvGrpSpPr/>
              <p:nvPr/>
            </p:nvGrpSpPr>
            <p:grpSpPr>
              <a:xfrm>
                <a:off x="3539508" y="6134567"/>
                <a:ext cx="1881306" cy="691684"/>
                <a:chOff x="808089" y="8146425"/>
                <a:chExt cx="1924197" cy="922244"/>
              </a:xfrm>
            </p:grpSpPr>
            <p:cxnSp>
              <p:nvCxnSpPr>
                <p:cNvPr id="8" name="Straight Connector 7"/>
                <p:cNvCxnSpPr/>
                <p:nvPr/>
              </p:nvCxnSpPr>
              <p:spPr>
                <a:xfrm>
                  <a:off x="808089" y="8157654"/>
                  <a:ext cx="1409554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5" name="Rectangle 114"/>
                <p:cNvSpPr/>
                <p:nvPr/>
              </p:nvSpPr>
              <p:spPr>
                <a:xfrm>
                  <a:off x="1148325" y="8378190"/>
                  <a:ext cx="364541" cy="29718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100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  <a:endParaRPr lang="en-US" sz="11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6" name="Rectangle 115"/>
                <p:cNvSpPr/>
                <p:nvPr/>
              </p:nvSpPr>
              <p:spPr>
                <a:xfrm>
                  <a:off x="1606140" y="8362425"/>
                  <a:ext cx="346041" cy="29718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100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5</a:t>
                  </a:r>
                  <a:endParaRPr lang="en-US" sz="11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7" name="Rectangle 116"/>
                <p:cNvSpPr/>
                <p:nvPr/>
              </p:nvSpPr>
              <p:spPr>
                <a:xfrm>
                  <a:off x="2050429" y="8367680"/>
                  <a:ext cx="346041" cy="297180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100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</a:t>
                  </a:r>
                  <a:endParaRPr lang="en-US" sz="11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125" name="Straight Connector 124"/>
                <p:cNvCxnSpPr/>
                <p:nvPr/>
              </p:nvCxnSpPr>
              <p:spPr>
                <a:xfrm>
                  <a:off x="817180" y="8153400"/>
                  <a:ext cx="0" cy="21600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7" name="Straight Connector 126"/>
                <p:cNvCxnSpPr/>
                <p:nvPr/>
              </p:nvCxnSpPr>
              <p:spPr>
                <a:xfrm>
                  <a:off x="1329560" y="8153400"/>
                  <a:ext cx="0" cy="21600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8" name="Straight Connector 127"/>
                <p:cNvCxnSpPr/>
                <p:nvPr/>
              </p:nvCxnSpPr>
              <p:spPr>
                <a:xfrm>
                  <a:off x="1798119" y="8146425"/>
                  <a:ext cx="0" cy="21600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9" name="Straight Connector 128"/>
                <p:cNvCxnSpPr/>
                <p:nvPr/>
              </p:nvCxnSpPr>
              <p:spPr>
                <a:xfrm>
                  <a:off x="2206361" y="8151680"/>
                  <a:ext cx="0" cy="21600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0" name="Rectangle 129"/>
                <p:cNvSpPr/>
                <p:nvPr/>
              </p:nvSpPr>
              <p:spPr>
                <a:xfrm>
                  <a:off x="835000" y="8725769"/>
                  <a:ext cx="985927" cy="34290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1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  <a:r>
                    <a:rPr lang="en-US" sz="1100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RI</a:t>
                  </a:r>
                  <a:endParaRPr lang="en-US" sz="11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ctr"/>
                  <a:r>
                    <a:rPr lang="en-US" sz="11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  <a:r>
                    <a:rPr lang="en-US" sz="1100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US</a:t>
                  </a:r>
                  <a:endParaRPr lang="en-US" sz="11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1" name="Rectangle 130"/>
                <p:cNvSpPr/>
                <p:nvPr/>
              </p:nvSpPr>
              <p:spPr>
                <a:xfrm>
                  <a:off x="1311809" y="8710004"/>
                  <a:ext cx="985927" cy="34290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1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  <a:r>
                    <a:rPr lang="en-US" sz="1100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RI</a:t>
                  </a:r>
                  <a:endParaRPr lang="en-US" sz="11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ctr"/>
                  <a:r>
                    <a:rPr lang="en-US" sz="11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  <a:r>
                    <a:rPr lang="en-US" sz="1100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US</a:t>
                  </a:r>
                  <a:endParaRPr lang="en-US" sz="11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32" name="Rectangle 131"/>
                <p:cNvSpPr/>
                <p:nvPr/>
              </p:nvSpPr>
              <p:spPr>
                <a:xfrm>
                  <a:off x="1746359" y="8710004"/>
                  <a:ext cx="985927" cy="342900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1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  <a:r>
                    <a:rPr lang="en-US" sz="1100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MRI</a:t>
                  </a:r>
                  <a:endParaRPr lang="en-US" sz="11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pPr algn="ctr"/>
                  <a:r>
                    <a:rPr lang="en-US" sz="11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-</a:t>
                  </a:r>
                  <a:r>
                    <a:rPr lang="en-US" sz="1100" dirty="0" smtClean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US</a:t>
                  </a:r>
                  <a:endParaRPr lang="en-US" sz="11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  <p:cxnSp>
          <p:nvCxnSpPr>
            <p:cNvPr id="9" name="Straight Connector 8"/>
            <p:cNvCxnSpPr/>
            <p:nvPr/>
          </p:nvCxnSpPr>
          <p:spPr>
            <a:xfrm flipH="1">
              <a:off x="2118567" y="1263021"/>
              <a:ext cx="520293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Straight Connector 152"/>
            <p:cNvCxnSpPr/>
            <p:nvPr/>
          </p:nvCxnSpPr>
          <p:spPr>
            <a:xfrm>
              <a:off x="2122584" y="1268730"/>
              <a:ext cx="1" cy="27432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Straight Connector 153"/>
            <p:cNvCxnSpPr/>
            <p:nvPr/>
          </p:nvCxnSpPr>
          <p:spPr>
            <a:xfrm>
              <a:off x="5008964" y="1274029"/>
              <a:ext cx="1" cy="27432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Straight Connector 154"/>
            <p:cNvCxnSpPr/>
            <p:nvPr/>
          </p:nvCxnSpPr>
          <p:spPr>
            <a:xfrm>
              <a:off x="7303466" y="1273837"/>
              <a:ext cx="1" cy="27432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6" name="Rectangle 155"/>
            <p:cNvSpPr/>
            <p:nvPr/>
          </p:nvSpPr>
          <p:spPr>
            <a:xfrm>
              <a:off x="1947672" y="1536690"/>
              <a:ext cx="338328" cy="22288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35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57" name="Elbow Connector 156"/>
            <p:cNvCxnSpPr/>
            <p:nvPr/>
          </p:nvCxnSpPr>
          <p:spPr>
            <a:xfrm rot="16200000" flipV="1">
              <a:off x="2293395" y="1787236"/>
              <a:ext cx="411480" cy="795528"/>
            </a:xfrm>
            <a:prstGeom prst="bentConnector3">
              <a:avLst>
                <a:gd name="adj1" fmla="val 48494"/>
              </a:avLst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8" name="Elbow Connector 157"/>
            <p:cNvCxnSpPr/>
            <p:nvPr/>
          </p:nvCxnSpPr>
          <p:spPr>
            <a:xfrm rot="5400000" flipH="1" flipV="1">
              <a:off x="1499945" y="1786612"/>
              <a:ext cx="411480" cy="795528"/>
            </a:xfrm>
            <a:prstGeom prst="bentConnector3">
              <a:avLst>
                <a:gd name="adj1" fmla="val 50000"/>
              </a:avLst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9" name="Rectangle 158"/>
            <p:cNvSpPr/>
            <p:nvPr/>
          </p:nvSpPr>
          <p:spPr>
            <a:xfrm>
              <a:off x="1130845" y="2412092"/>
              <a:ext cx="338328" cy="22288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sp>
          <p:nvSpPr>
            <p:cNvPr id="160" name="Rectangle 159"/>
            <p:cNvSpPr/>
            <p:nvPr/>
          </p:nvSpPr>
          <p:spPr>
            <a:xfrm>
              <a:off x="2743200" y="2409731"/>
              <a:ext cx="338328" cy="22288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</a:p>
          </p:txBody>
        </p:sp>
        <p:sp>
          <p:nvSpPr>
            <p:cNvPr id="161" name="Rectangle 160"/>
            <p:cNvSpPr/>
            <p:nvPr/>
          </p:nvSpPr>
          <p:spPr>
            <a:xfrm>
              <a:off x="2412110" y="2635477"/>
              <a:ext cx="1010860" cy="25717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H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9" name="Rectangle 218"/>
            <p:cNvSpPr/>
            <p:nvPr/>
          </p:nvSpPr>
          <p:spPr>
            <a:xfrm>
              <a:off x="1508512" y="1714504"/>
              <a:ext cx="1201827" cy="257174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Healthy joints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4" name="Rectangle 223"/>
            <p:cNvSpPr/>
            <p:nvPr/>
          </p:nvSpPr>
          <p:spPr>
            <a:xfrm>
              <a:off x="3732435" y="3430867"/>
              <a:ext cx="338328" cy="22288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</a:p>
          </p:txBody>
        </p:sp>
        <p:grpSp>
          <p:nvGrpSpPr>
            <p:cNvPr id="210" name="Group 209"/>
            <p:cNvGrpSpPr/>
            <p:nvPr/>
          </p:nvGrpSpPr>
          <p:grpSpPr>
            <a:xfrm>
              <a:off x="2171230" y="2903169"/>
              <a:ext cx="1514401" cy="752943"/>
              <a:chOff x="266229" y="2865415"/>
              <a:chExt cx="1514401" cy="752943"/>
            </a:xfrm>
          </p:grpSpPr>
          <p:sp>
            <p:nvSpPr>
              <p:cNvPr id="229" name="Rectangle 228"/>
              <p:cNvSpPr/>
              <p:nvPr/>
            </p:nvSpPr>
            <p:spPr>
              <a:xfrm>
                <a:off x="266229" y="3392155"/>
                <a:ext cx="338328" cy="222885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</a:p>
            </p:txBody>
          </p:sp>
          <p:grpSp>
            <p:nvGrpSpPr>
              <p:cNvPr id="233" name="Group 232"/>
              <p:cNvGrpSpPr/>
              <p:nvPr/>
            </p:nvGrpSpPr>
            <p:grpSpPr>
              <a:xfrm>
                <a:off x="471887" y="2865415"/>
                <a:ext cx="1308743" cy="752943"/>
                <a:chOff x="471887" y="2865415"/>
                <a:chExt cx="1308743" cy="752943"/>
              </a:xfrm>
            </p:grpSpPr>
            <p:cxnSp>
              <p:nvCxnSpPr>
                <p:cNvPr id="236" name="Elbow Connector 235"/>
                <p:cNvCxnSpPr/>
                <p:nvPr/>
              </p:nvCxnSpPr>
              <p:spPr>
                <a:xfrm rot="16200000" flipV="1">
                  <a:off x="1067213" y="2854458"/>
                  <a:ext cx="342900" cy="365760"/>
                </a:xfrm>
                <a:prstGeom prst="bentConnector3">
                  <a:avLst>
                    <a:gd name="adj1" fmla="val 50000"/>
                  </a:avLst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7" name="Elbow Connector 236"/>
                <p:cNvCxnSpPr/>
                <p:nvPr/>
              </p:nvCxnSpPr>
              <p:spPr>
                <a:xfrm rot="5400000" flipH="1" flipV="1">
                  <a:off x="708247" y="2853985"/>
                  <a:ext cx="342900" cy="365760"/>
                </a:xfrm>
                <a:prstGeom prst="bentConnector3">
                  <a:avLst>
                    <a:gd name="adj1" fmla="val 50000"/>
                  </a:avLst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8" name="Rectangle 237"/>
                <p:cNvSpPr/>
                <p:nvPr/>
              </p:nvSpPr>
              <p:spPr>
                <a:xfrm>
                  <a:off x="652632" y="3392155"/>
                  <a:ext cx="338328" cy="222885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2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9</a:t>
                  </a:r>
                </a:p>
              </p:txBody>
            </p:sp>
            <p:sp>
              <p:nvSpPr>
                <p:cNvPr id="239" name="Rectangle 238"/>
                <p:cNvSpPr/>
                <p:nvPr/>
              </p:nvSpPr>
              <p:spPr>
                <a:xfrm>
                  <a:off x="1063221" y="3394217"/>
                  <a:ext cx="338328" cy="222885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2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</a:t>
                  </a:r>
                </a:p>
              </p:txBody>
            </p:sp>
            <p:sp>
              <p:nvSpPr>
                <p:cNvPr id="240" name="Rectangle 239"/>
                <p:cNvSpPr/>
                <p:nvPr/>
              </p:nvSpPr>
              <p:spPr>
                <a:xfrm>
                  <a:off x="1442302" y="3395473"/>
                  <a:ext cx="338328" cy="222885"/>
                </a:xfrm>
                <a:prstGeom prst="rect">
                  <a:avLst/>
                </a:prstGeom>
                <a:noFill/>
                <a:ln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sz="12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</a:t>
                  </a:r>
                </a:p>
              </p:txBody>
            </p:sp>
            <p:cxnSp>
              <p:nvCxnSpPr>
                <p:cNvPr id="241" name="Straight Connector 240"/>
                <p:cNvCxnSpPr/>
                <p:nvPr/>
              </p:nvCxnSpPr>
              <p:spPr>
                <a:xfrm>
                  <a:off x="471887" y="3213228"/>
                  <a:ext cx="36576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2" name="Straight Connector 241"/>
                <p:cNvCxnSpPr/>
                <p:nvPr/>
              </p:nvCxnSpPr>
              <p:spPr>
                <a:xfrm>
                  <a:off x="490524" y="3215720"/>
                  <a:ext cx="0" cy="160351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3" name="Straight Connector 242"/>
                <p:cNvCxnSpPr/>
                <p:nvPr/>
              </p:nvCxnSpPr>
              <p:spPr>
                <a:xfrm>
                  <a:off x="826619" y="3216089"/>
                  <a:ext cx="0" cy="160351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4" name="Straight Connector 243"/>
                <p:cNvCxnSpPr/>
                <p:nvPr/>
              </p:nvCxnSpPr>
              <p:spPr>
                <a:xfrm>
                  <a:off x="1249679" y="3226056"/>
                  <a:ext cx="365760" cy="0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5" name="Straight Connector 244"/>
                <p:cNvCxnSpPr/>
                <p:nvPr/>
              </p:nvCxnSpPr>
              <p:spPr>
                <a:xfrm>
                  <a:off x="1259915" y="3224606"/>
                  <a:ext cx="0" cy="160351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6" name="Straight Connector 245"/>
                <p:cNvCxnSpPr/>
                <p:nvPr/>
              </p:nvCxnSpPr>
              <p:spPr>
                <a:xfrm>
                  <a:off x="1606743" y="3221825"/>
                  <a:ext cx="0" cy="160351"/>
                </a:xfrm>
                <a:prstGeom prst="line">
                  <a:avLst/>
                </a:prstGeom>
                <a:ln w="254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289" name="Rectangle 288"/>
            <p:cNvSpPr/>
            <p:nvPr/>
          </p:nvSpPr>
          <p:spPr>
            <a:xfrm>
              <a:off x="5601149" y="1913782"/>
              <a:ext cx="1333051" cy="33994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n CBCT imaging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1" name="Rectangle 290"/>
            <p:cNvSpPr/>
            <p:nvPr/>
          </p:nvSpPr>
          <p:spPr>
            <a:xfrm>
              <a:off x="1718056" y="3001198"/>
              <a:ext cx="1333051" cy="33994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n US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2" name="Rectangle 291"/>
            <p:cNvSpPr/>
            <p:nvPr/>
          </p:nvSpPr>
          <p:spPr>
            <a:xfrm>
              <a:off x="3014244" y="2989731"/>
              <a:ext cx="1177651" cy="33994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n MRI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3" name="Rectangle 292"/>
            <p:cNvSpPr/>
            <p:nvPr/>
          </p:nvSpPr>
          <p:spPr>
            <a:xfrm>
              <a:off x="1317291" y="3003064"/>
              <a:ext cx="1177651" cy="33994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n US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4" name="Rectangle 293"/>
            <p:cNvSpPr/>
            <p:nvPr/>
          </p:nvSpPr>
          <p:spPr>
            <a:xfrm>
              <a:off x="1319514" y="3632486"/>
              <a:ext cx="354303" cy="25717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J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6" name="Rectangle 295"/>
            <p:cNvSpPr/>
            <p:nvPr/>
          </p:nvSpPr>
          <p:spPr>
            <a:xfrm>
              <a:off x="2947559" y="3634279"/>
              <a:ext cx="354303" cy="25717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J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7" name="Rectangle 296"/>
            <p:cNvSpPr/>
            <p:nvPr/>
          </p:nvSpPr>
          <p:spPr>
            <a:xfrm>
              <a:off x="2541298" y="3635191"/>
              <a:ext cx="354303" cy="25717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J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8" name="Rectangle 297"/>
            <p:cNvSpPr/>
            <p:nvPr/>
          </p:nvSpPr>
          <p:spPr>
            <a:xfrm>
              <a:off x="826969" y="3629492"/>
              <a:ext cx="494659" cy="25717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D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9" name="Rectangle 298"/>
            <p:cNvSpPr/>
            <p:nvPr/>
          </p:nvSpPr>
          <p:spPr>
            <a:xfrm>
              <a:off x="3653309" y="3636085"/>
              <a:ext cx="494659" cy="25717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D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0" name="Rectangle 299"/>
            <p:cNvSpPr/>
            <p:nvPr/>
          </p:nvSpPr>
          <p:spPr>
            <a:xfrm>
              <a:off x="1371601" y="3635450"/>
              <a:ext cx="1010860" cy="25717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H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1" name="Rectangle 300"/>
            <p:cNvSpPr/>
            <p:nvPr/>
          </p:nvSpPr>
          <p:spPr>
            <a:xfrm>
              <a:off x="1833953" y="3637300"/>
              <a:ext cx="1010860" cy="25717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H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2" name="Rectangle 301"/>
            <p:cNvSpPr/>
            <p:nvPr/>
          </p:nvSpPr>
          <p:spPr>
            <a:xfrm>
              <a:off x="3000733" y="3639294"/>
              <a:ext cx="1010860" cy="25717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H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99" name="Straight Connector 198"/>
            <p:cNvCxnSpPr/>
            <p:nvPr/>
          </p:nvCxnSpPr>
          <p:spPr>
            <a:xfrm>
              <a:off x="3493560" y="3263860"/>
              <a:ext cx="36576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1" name="Straight Connector 200"/>
            <p:cNvCxnSpPr/>
            <p:nvPr/>
          </p:nvCxnSpPr>
          <p:spPr>
            <a:xfrm>
              <a:off x="3851063" y="3261626"/>
              <a:ext cx="0" cy="160351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2" name="Rectangle 201"/>
            <p:cNvSpPr/>
            <p:nvPr/>
          </p:nvSpPr>
          <p:spPr>
            <a:xfrm>
              <a:off x="3776255" y="4242920"/>
              <a:ext cx="963951" cy="25717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rt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3" name="Rectangle 202"/>
            <p:cNvSpPr/>
            <p:nvPr/>
          </p:nvSpPr>
          <p:spPr>
            <a:xfrm>
              <a:off x="7451989" y="4247599"/>
              <a:ext cx="1307246" cy="257175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OA</a:t>
              </a:r>
              <a:endParaRPr lang="en-US" sz="11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04" name="Straight Arrow Connector 203"/>
            <p:cNvCxnSpPr/>
            <p:nvPr/>
          </p:nvCxnSpPr>
          <p:spPr>
            <a:xfrm flipH="1">
              <a:off x="5014851" y="939587"/>
              <a:ext cx="968400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3" name="TextBox 162"/>
          <p:cNvSpPr txBox="1"/>
          <p:nvPr/>
        </p:nvSpPr>
        <p:spPr>
          <a:xfrm>
            <a:off x="402921" y="296218"/>
            <a:ext cx="78899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1</a:t>
            </a:r>
            <a:endParaRPr lang="en-US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64" name="Straight Arrow Connector 163"/>
          <p:cNvCxnSpPr/>
          <p:nvPr/>
        </p:nvCxnSpPr>
        <p:spPr>
          <a:xfrm flipH="1">
            <a:off x="2101371" y="2080949"/>
            <a:ext cx="64008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7" name="Straight Arrow Connector 166"/>
          <p:cNvCxnSpPr/>
          <p:nvPr/>
        </p:nvCxnSpPr>
        <p:spPr>
          <a:xfrm flipH="1">
            <a:off x="5059788" y="2102727"/>
            <a:ext cx="64008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8" name="Straight Arrow Connector 167"/>
          <p:cNvCxnSpPr/>
          <p:nvPr/>
        </p:nvCxnSpPr>
        <p:spPr>
          <a:xfrm flipH="1">
            <a:off x="7320188" y="2092094"/>
            <a:ext cx="640080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905100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oup 13"/>
          <p:cNvGrpSpPr/>
          <p:nvPr/>
        </p:nvGrpSpPr>
        <p:grpSpPr>
          <a:xfrm>
            <a:off x="114982" y="389964"/>
            <a:ext cx="9019874" cy="4665741"/>
            <a:chOff x="114982" y="389964"/>
            <a:chExt cx="9019874" cy="4665741"/>
          </a:xfrm>
        </p:grpSpPr>
        <p:sp>
          <p:nvSpPr>
            <p:cNvPr id="20" name="Rectangle 19"/>
            <p:cNvSpPr/>
            <p:nvPr/>
          </p:nvSpPr>
          <p:spPr>
            <a:xfrm>
              <a:off x="5323398" y="3229586"/>
              <a:ext cx="3611880" cy="36576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3" name="Chart 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934577769"/>
                </p:ext>
              </p:extLst>
            </p:nvPr>
          </p:nvGraphicFramePr>
          <p:xfrm>
            <a:off x="4937760" y="2133600"/>
            <a:ext cx="4197096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9" name="Rectangle 18"/>
            <p:cNvSpPr/>
            <p:nvPr/>
          </p:nvSpPr>
          <p:spPr>
            <a:xfrm>
              <a:off x="755309" y="3226994"/>
              <a:ext cx="3611880" cy="36576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100" dirty="0" smtClean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2" name="Chart 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28148291"/>
                </p:ext>
              </p:extLst>
            </p:nvPr>
          </p:nvGraphicFramePr>
          <p:xfrm>
            <a:off x="380846" y="2130870"/>
            <a:ext cx="4197096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4" name="TextBox 3"/>
            <p:cNvSpPr txBox="1"/>
            <p:nvPr/>
          </p:nvSpPr>
          <p:spPr>
            <a:xfrm>
              <a:off x="1828800" y="1739657"/>
              <a:ext cx="140262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ure Arthralgia</a:t>
              </a:r>
              <a:endPara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6269019" y="1752478"/>
              <a:ext cx="1848583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     Osteoarthritis</a:t>
              </a:r>
            </a:p>
            <a:p>
              <a:r>
                <a:rPr lang="da-DK" sz="14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combined diagnosis) </a:t>
              </a:r>
              <a:endParaRPr lang="en-GB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TextBox 26"/>
            <p:cNvSpPr txBox="1">
              <a:spLocks noChangeArrowheads="1"/>
            </p:cNvSpPr>
            <p:nvPr/>
          </p:nvSpPr>
          <p:spPr bwMode="auto">
            <a:xfrm>
              <a:off x="1968916" y="4753232"/>
              <a:ext cx="1273206" cy="3024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116668" tIns="58334" rIns="116668" bIns="58334">
              <a:spAutoFit/>
            </a:bodyPr>
            <a:lstStyle>
              <a:lvl1pPr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1pPr>
              <a:lvl2pPr marL="742950" indent="-28575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2pPr>
              <a:lvl3pPr marL="11430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3pPr>
              <a:lvl4pPr marL="16002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4pPr>
              <a:lvl5pPr marL="20574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9pPr>
            </a:lstStyle>
            <a:p>
              <a:pPr>
                <a:buFontTx/>
                <a:buNone/>
              </a:pPr>
              <a:r>
                <a:rPr lang="da-DK" sz="1200" dirty="0">
                  <a:solidFill>
                    <a:schemeClr val="tx1"/>
                  </a:solidFill>
                  <a:latin typeface="Times New Roman" panose="02020603050405020304" pitchFamily="18" charset="0"/>
                  <a:ea typeface="Verdana" pitchFamily="34" charset="0"/>
                  <a:cs typeface="Times New Roman" panose="02020603050405020304" pitchFamily="18" charset="0"/>
                </a:rPr>
                <a:t>QST parameter</a:t>
              </a:r>
            </a:p>
          </p:txBody>
        </p:sp>
        <p:sp>
          <p:nvSpPr>
            <p:cNvPr id="7" name="TextBox 26"/>
            <p:cNvSpPr txBox="1">
              <a:spLocks noChangeArrowheads="1"/>
            </p:cNvSpPr>
            <p:nvPr/>
          </p:nvSpPr>
          <p:spPr bwMode="auto">
            <a:xfrm>
              <a:off x="6562970" y="4750905"/>
              <a:ext cx="1273206" cy="30247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 lIns="116668" tIns="58334" rIns="116668" bIns="58334">
              <a:spAutoFit/>
            </a:bodyPr>
            <a:lstStyle>
              <a:lvl1pPr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1pPr>
              <a:lvl2pPr marL="742950" indent="-28575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2pPr>
              <a:lvl3pPr marL="11430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3pPr>
              <a:lvl4pPr marL="16002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4pPr>
              <a:lvl5pPr marL="20574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9pPr>
            </a:lstStyle>
            <a:p>
              <a:pPr>
                <a:buFontTx/>
                <a:buNone/>
              </a:pPr>
              <a:r>
                <a:rPr lang="da-DK" sz="1200" dirty="0">
                  <a:solidFill>
                    <a:schemeClr val="tx1"/>
                  </a:solidFill>
                  <a:latin typeface="Times New Roman" panose="02020603050405020304" pitchFamily="18" charset="0"/>
                  <a:ea typeface="Verdana" pitchFamily="34" charset="0"/>
                  <a:cs typeface="Times New Roman" panose="02020603050405020304" pitchFamily="18" charset="0"/>
                </a:rPr>
                <a:t>QST parameter</a:t>
              </a:r>
            </a:p>
          </p:txBody>
        </p:sp>
        <p:sp>
          <p:nvSpPr>
            <p:cNvPr id="8" name="TextBox 163"/>
            <p:cNvSpPr txBox="1">
              <a:spLocks noChangeArrowheads="1"/>
            </p:cNvSpPr>
            <p:nvPr/>
          </p:nvSpPr>
          <p:spPr bwMode="auto">
            <a:xfrm rot="16200000">
              <a:off x="3432" y="3227162"/>
              <a:ext cx="761683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1pPr>
              <a:lvl2pPr marL="742950" indent="-28575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2pPr>
              <a:lvl3pPr marL="11430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3pPr>
              <a:lvl4pPr marL="16002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4pPr>
              <a:lvl5pPr marL="20574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9pPr>
            </a:lstStyle>
            <a:p>
              <a:pPr>
                <a:buFontTx/>
                <a:buNone/>
              </a:pPr>
              <a:r>
                <a:rPr lang="da-DK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Verdana" pitchFamily="34" charset="0"/>
                  <a:cs typeface="Times New Roman" panose="02020603050405020304" pitchFamily="18" charset="0"/>
                </a:rPr>
                <a:t>Z-score</a:t>
              </a:r>
            </a:p>
          </p:txBody>
        </p:sp>
        <p:sp>
          <p:nvSpPr>
            <p:cNvPr id="9" name="TextBox 163"/>
            <p:cNvSpPr txBox="1">
              <a:spLocks noChangeArrowheads="1"/>
            </p:cNvSpPr>
            <p:nvPr/>
          </p:nvSpPr>
          <p:spPr bwMode="auto">
            <a:xfrm rot="16200000">
              <a:off x="4570670" y="3220758"/>
              <a:ext cx="761683" cy="3077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1pPr>
              <a:lvl2pPr marL="742950" indent="-28575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2pPr>
              <a:lvl3pPr marL="11430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3pPr>
              <a:lvl4pPr marL="16002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4pPr>
              <a:lvl5pPr marL="20574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9pPr>
            </a:lstStyle>
            <a:p>
              <a:pPr>
                <a:buFontTx/>
                <a:buNone/>
              </a:pPr>
              <a:r>
                <a:rPr lang="da-DK" sz="1400" dirty="0">
                  <a:solidFill>
                    <a:schemeClr val="tx1"/>
                  </a:solidFill>
                  <a:latin typeface="Times New Roman" panose="02020603050405020304" pitchFamily="18" charset="0"/>
                  <a:ea typeface="Verdana" pitchFamily="34" charset="0"/>
                  <a:cs typeface="Times New Roman" panose="02020603050405020304" pitchFamily="18" charset="0"/>
                </a:rPr>
                <a:t>Z-score</a:t>
              </a:r>
            </a:p>
          </p:txBody>
        </p:sp>
        <p:sp>
          <p:nvSpPr>
            <p:cNvPr id="10" name="Down Arrow 9"/>
            <p:cNvSpPr/>
            <p:nvPr/>
          </p:nvSpPr>
          <p:spPr>
            <a:xfrm>
              <a:off x="356114" y="3771703"/>
              <a:ext cx="100584" cy="731520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Down Arrow 10"/>
            <p:cNvSpPr/>
            <p:nvPr/>
          </p:nvSpPr>
          <p:spPr>
            <a:xfrm flipV="1">
              <a:off x="368918" y="2246976"/>
              <a:ext cx="91440" cy="731520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Down Arrow 11"/>
            <p:cNvSpPr/>
            <p:nvPr/>
          </p:nvSpPr>
          <p:spPr>
            <a:xfrm flipV="1">
              <a:off x="4907943" y="2261411"/>
              <a:ext cx="91440" cy="731520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Down Arrow 12"/>
            <p:cNvSpPr/>
            <p:nvPr/>
          </p:nvSpPr>
          <p:spPr>
            <a:xfrm>
              <a:off x="4920813" y="3773556"/>
              <a:ext cx="100584" cy="731520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Box 163"/>
            <p:cNvSpPr txBox="1">
              <a:spLocks noChangeArrowheads="1"/>
            </p:cNvSpPr>
            <p:nvPr/>
          </p:nvSpPr>
          <p:spPr bwMode="auto">
            <a:xfrm rot="16200000">
              <a:off x="-292659" y="2525098"/>
              <a:ext cx="10807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1pPr>
              <a:lvl2pPr marL="742950" indent="-28575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2pPr>
              <a:lvl3pPr marL="11430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3pPr>
              <a:lvl4pPr marL="16002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4pPr>
              <a:lvl5pPr marL="20574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9pPr>
            </a:lstStyle>
            <a:p>
              <a:pPr>
                <a:buFontTx/>
                <a:buNone/>
              </a:pPr>
              <a:r>
                <a:rPr lang="da-DK" sz="10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Verdana" pitchFamily="34" charset="0"/>
                  <a:cs typeface="Times New Roman" panose="02020603050405020304" pitchFamily="18" charset="0"/>
                </a:rPr>
                <a:t>Gain of function</a:t>
              </a:r>
              <a:endParaRPr lang="da-DK" sz="1000" dirty="0">
                <a:solidFill>
                  <a:schemeClr val="tx1"/>
                </a:solidFill>
                <a:latin typeface="Times New Roman" panose="02020603050405020304" pitchFamily="18" charset="0"/>
                <a:ea typeface="Verdana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Box 163"/>
            <p:cNvSpPr txBox="1">
              <a:spLocks noChangeArrowheads="1"/>
            </p:cNvSpPr>
            <p:nvPr/>
          </p:nvSpPr>
          <p:spPr bwMode="auto">
            <a:xfrm rot="16200000">
              <a:off x="4244460" y="2523938"/>
              <a:ext cx="1080745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1pPr>
              <a:lvl2pPr marL="742950" indent="-28575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2pPr>
              <a:lvl3pPr marL="11430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3pPr>
              <a:lvl4pPr marL="16002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4pPr>
              <a:lvl5pPr marL="20574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9pPr>
            </a:lstStyle>
            <a:p>
              <a:pPr>
                <a:buFontTx/>
                <a:buNone/>
              </a:pPr>
              <a:r>
                <a:rPr lang="da-DK" sz="10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Verdana" pitchFamily="34" charset="0"/>
                  <a:cs typeface="Times New Roman" panose="02020603050405020304" pitchFamily="18" charset="0"/>
                </a:rPr>
                <a:t>Gain of function</a:t>
              </a:r>
              <a:endParaRPr lang="da-DK" sz="1000" dirty="0">
                <a:solidFill>
                  <a:schemeClr val="tx1"/>
                </a:solidFill>
                <a:latin typeface="Times New Roman" panose="02020603050405020304" pitchFamily="18" charset="0"/>
                <a:ea typeface="Verdana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TextBox 163"/>
            <p:cNvSpPr txBox="1">
              <a:spLocks noChangeArrowheads="1"/>
            </p:cNvSpPr>
            <p:nvPr/>
          </p:nvSpPr>
          <p:spPr bwMode="auto">
            <a:xfrm rot="16200000">
              <a:off x="-291860" y="4013571"/>
              <a:ext cx="105990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1pPr>
              <a:lvl2pPr marL="742950" indent="-28575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2pPr>
              <a:lvl3pPr marL="11430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3pPr>
              <a:lvl4pPr marL="16002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4pPr>
              <a:lvl5pPr marL="20574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9pPr>
            </a:lstStyle>
            <a:p>
              <a:pPr>
                <a:buFontTx/>
                <a:buNone/>
              </a:pPr>
              <a:r>
                <a:rPr lang="da-DK" sz="10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Verdana" pitchFamily="34" charset="0"/>
                  <a:cs typeface="Times New Roman" panose="02020603050405020304" pitchFamily="18" charset="0"/>
                </a:rPr>
                <a:t>Loss of function</a:t>
              </a:r>
              <a:endParaRPr lang="da-DK" sz="1000" dirty="0">
                <a:solidFill>
                  <a:schemeClr val="tx1"/>
                </a:solidFill>
                <a:latin typeface="Times New Roman" panose="02020603050405020304" pitchFamily="18" charset="0"/>
                <a:ea typeface="Verdana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TextBox 163"/>
            <p:cNvSpPr txBox="1">
              <a:spLocks noChangeArrowheads="1"/>
            </p:cNvSpPr>
            <p:nvPr/>
          </p:nvSpPr>
          <p:spPr bwMode="auto">
            <a:xfrm rot="16200000">
              <a:off x="4281466" y="4023512"/>
              <a:ext cx="1059906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1pPr>
              <a:lvl2pPr marL="742950" indent="-28575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2pPr>
              <a:lvl3pPr marL="11430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3pPr>
              <a:lvl4pPr marL="16002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4pPr>
              <a:lvl5pPr marL="20574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9pPr>
            </a:lstStyle>
            <a:p>
              <a:pPr>
                <a:buFontTx/>
                <a:buNone/>
              </a:pPr>
              <a:r>
                <a:rPr lang="da-DK" sz="1000" dirty="0" smtClean="0">
                  <a:solidFill>
                    <a:schemeClr val="tx1"/>
                  </a:solidFill>
                  <a:latin typeface="Times New Roman" panose="02020603050405020304" pitchFamily="18" charset="0"/>
                  <a:ea typeface="Verdana" pitchFamily="34" charset="0"/>
                  <a:cs typeface="Times New Roman" panose="02020603050405020304" pitchFamily="18" charset="0"/>
                </a:rPr>
                <a:t>Loss of function</a:t>
              </a:r>
              <a:endParaRPr lang="da-DK" sz="1000" dirty="0">
                <a:solidFill>
                  <a:schemeClr val="tx1"/>
                </a:solidFill>
                <a:latin typeface="Times New Roman" panose="02020603050405020304" pitchFamily="18" charset="0"/>
                <a:ea typeface="Verdana" pitchFamily="34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1" name="Straight Connector 20"/>
            <p:cNvCxnSpPr/>
            <p:nvPr/>
          </p:nvCxnSpPr>
          <p:spPr>
            <a:xfrm>
              <a:off x="742723" y="3409214"/>
              <a:ext cx="3657600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>
              <a:off x="5293581" y="3415871"/>
              <a:ext cx="3657600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TextBox 22"/>
            <p:cNvSpPr txBox="1"/>
            <p:nvPr/>
          </p:nvSpPr>
          <p:spPr>
            <a:xfrm>
              <a:off x="247713" y="389964"/>
              <a:ext cx="78899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S2</a:t>
              </a:r>
              <a:endPara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488047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258501" y="347246"/>
            <a:ext cx="8651377" cy="4642678"/>
            <a:chOff x="258501" y="347246"/>
            <a:chExt cx="8651377" cy="4642678"/>
          </a:xfrm>
        </p:grpSpPr>
        <p:sp>
          <p:nvSpPr>
            <p:cNvPr id="6" name="TextBox 5"/>
            <p:cNvSpPr txBox="1"/>
            <p:nvPr/>
          </p:nvSpPr>
          <p:spPr>
            <a:xfrm rot="16200000">
              <a:off x="-54405" y="3279785"/>
              <a:ext cx="9028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PT (kPa)</a:t>
              </a:r>
              <a:endPara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 rot="16200000">
              <a:off x="4106694" y="3279784"/>
              <a:ext cx="90281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PT (kPa)</a:t>
              </a:r>
              <a:endParaRPr lang="en-GB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2296890" y="1871246"/>
              <a:ext cx="617477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MJ</a:t>
              </a:r>
              <a:endPara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096000" y="1871246"/>
              <a:ext cx="83388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henar</a:t>
              </a:r>
              <a:endPara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6" name="Group 15"/>
            <p:cNvGrpSpPr/>
            <p:nvPr/>
          </p:nvGrpSpPr>
          <p:grpSpPr>
            <a:xfrm>
              <a:off x="8124281" y="1807033"/>
              <a:ext cx="785597" cy="712557"/>
              <a:chOff x="8217934" y="2657809"/>
              <a:chExt cx="785597" cy="712557"/>
            </a:xfrm>
          </p:grpSpPr>
          <p:sp>
            <p:nvSpPr>
              <p:cNvPr id="17" name="Rectangle 16"/>
              <p:cNvSpPr/>
              <p:nvPr/>
            </p:nvSpPr>
            <p:spPr>
              <a:xfrm>
                <a:off x="8217934" y="2708920"/>
                <a:ext cx="144000" cy="1440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Rectangle 17"/>
              <p:cNvSpPr/>
              <p:nvPr/>
            </p:nvSpPr>
            <p:spPr>
              <a:xfrm>
                <a:off x="8219612" y="2944360"/>
                <a:ext cx="144000" cy="144000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Rectangle 18"/>
              <p:cNvSpPr/>
              <p:nvPr/>
            </p:nvSpPr>
            <p:spPr>
              <a:xfrm>
                <a:off x="8233192" y="3175256"/>
                <a:ext cx="144000" cy="144000"/>
              </a:xfrm>
              <a:prstGeom prst="rect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>
                  <a:solidFill>
                    <a:schemeClr val="bg1">
                      <a:lumMod val="50000"/>
                    </a:schemeClr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8363612" y="2657809"/>
                <a:ext cx="63991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aseline</a:t>
                </a:r>
                <a:endPara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8363298" y="2894747"/>
                <a:ext cx="59824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uring</a:t>
                </a:r>
                <a:endPara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8377812" y="3124145"/>
                <a:ext cx="48442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a-DK" sz="10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fter</a:t>
                </a:r>
                <a:endParaRPr lang="en-GB" sz="10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3" name="TextBox 22"/>
            <p:cNvSpPr txBox="1"/>
            <p:nvPr/>
          </p:nvSpPr>
          <p:spPr>
            <a:xfrm>
              <a:off x="3472064" y="990600"/>
              <a:ext cx="195919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mbined diagnosis</a:t>
              </a:r>
              <a:endPara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aphicFrame>
          <p:nvGraphicFramePr>
            <p:cNvPr id="24" name="Chart 2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708042326"/>
                </p:ext>
              </p:extLst>
            </p:nvPr>
          </p:nvGraphicFramePr>
          <p:xfrm>
            <a:off x="494859" y="2246724"/>
            <a:ext cx="3810000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25" name="Chart 24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88622717"/>
                </p:ext>
              </p:extLst>
            </p:nvPr>
          </p:nvGraphicFramePr>
          <p:xfrm>
            <a:off x="4602339" y="2234742"/>
            <a:ext cx="3813048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sp>
          <p:nvSpPr>
            <p:cNvPr id="28" name="Text Box 13"/>
            <p:cNvSpPr txBox="1">
              <a:spLocks noChangeArrowheads="1"/>
            </p:cNvSpPr>
            <p:nvPr/>
          </p:nvSpPr>
          <p:spPr bwMode="auto">
            <a:xfrm>
              <a:off x="7843466" y="2948115"/>
              <a:ext cx="389845" cy="4255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miter lim="800000"/>
                  <a:headEnd type="none" w="sm" len="sm"/>
                  <a:tailEnd type="none" w="sm" len="sm"/>
                </a14:hiddenLine>
              </a:ext>
            </a:extLst>
          </p:spPr>
          <p:txBody>
            <a:bodyPr lIns="116668" tIns="58334" rIns="116668" bIns="58334">
              <a:spAutoFit/>
            </a:bodyPr>
            <a:lstStyle>
              <a:lvl1pPr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1pPr>
              <a:lvl2pPr marL="742950" indent="-28575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2pPr>
              <a:lvl3pPr marL="11430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3pPr>
              <a:lvl4pPr marL="16002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4pPr>
              <a:lvl5pPr marL="20574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9pPr>
            </a:lstStyle>
            <a:p>
              <a:pPr>
                <a:buFontTx/>
                <a:buNone/>
              </a:pPr>
              <a:r>
                <a:rPr lang="da-DK" sz="2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sz="2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xt Box 13"/>
            <p:cNvSpPr txBox="1">
              <a:spLocks noChangeArrowheads="1"/>
            </p:cNvSpPr>
            <p:nvPr/>
          </p:nvSpPr>
          <p:spPr bwMode="auto">
            <a:xfrm>
              <a:off x="6739696" y="2659990"/>
              <a:ext cx="389845" cy="4255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miter lim="800000"/>
                  <a:headEnd type="none" w="sm" len="sm"/>
                  <a:tailEnd type="none" w="sm" len="sm"/>
                </a14:hiddenLine>
              </a:ext>
            </a:extLst>
          </p:spPr>
          <p:txBody>
            <a:bodyPr lIns="116668" tIns="58334" rIns="116668" bIns="58334">
              <a:spAutoFit/>
            </a:bodyPr>
            <a:lstStyle>
              <a:lvl1pPr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1pPr>
              <a:lvl2pPr marL="742950" indent="-28575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2pPr>
              <a:lvl3pPr marL="11430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3pPr>
              <a:lvl4pPr marL="16002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4pPr>
              <a:lvl5pPr marL="20574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9pPr>
            </a:lstStyle>
            <a:p>
              <a:pPr>
                <a:buFontTx/>
                <a:buNone/>
              </a:pPr>
              <a:r>
                <a:rPr lang="da-DK" sz="2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sz="2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Text Box 13"/>
            <p:cNvSpPr txBox="1">
              <a:spLocks noChangeArrowheads="1"/>
            </p:cNvSpPr>
            <p:nvPr/>
          </p:nvSpPr>
          <p:spPr bwMode="auto">
            <a:xfrm>
              <a:off x="5640839" y="2306754"/>
              <a:ext cx="389845" cy="4255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miter lim="800000"/>
                  <a:headEnd type="none" w="sm" len="sm"/>
                  <a:tailEnd type="none" w="sm" len="sm"/>
                </a14:hiddenLine>
              </a:ext>
            </a:extLst>
          </p:spPr>
          <p:txBody>
            <a:bodyPr lIns="116668" tIns="58334" rIns="116668" bIns="58334">
              <a:spAutoFit/>
            </a:bodyPr>
            <a:lstStyle>
              <a:lvl1pPr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1pPr>
              <a:lvl2pPr marL="742950" indent="-28575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2pPr>
              <a:lvl3pPr marL="11430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3pPr>
              <a:lvl4pPr marL="16002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4pPr>
              <a:lvl5pPr marL="20574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9pPr>
            </a:lstStyle>
            <a:p>
              <a:pPr>
                <a:buFontTx/>
                <a:buNone/>
              </a:pPr>
              <a:r>
                <a:rPr lang="da-DK" sz="2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sz="2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Text Box 13"/>
            <p:cNvSpPr txBox="1">
              <a:spLocks noChangeArrowheads="1"/>
            </p:cNvSpPr>
            <p:nvPr/>
          </p:nvSpPr>
          <p:spPr bwMode="auto">
            <a:xfrm>
              <a:off x="1524089" y="2306754"/>
              <a:ext cx="389845" cy="4255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miter lim="800000"/>
                  <a:headEnd type="none" w="sm" len="sm"/>
                  <a:tailEnd type="none" w="sm" len="sm"/>
                </a14:hiddenLine>
              </a:ext>
            </a:extLst>
          </p:spPr>
          <p:txBody>
            <a:bodyPr lIns="116668" tIns="58334" rIns="116668" bIns="58334">
              <a:spAutoFit/>
            </a:bodyPr>
            <a:lstStyle>
              <a:lvl1pPr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1pPr>
              <a:lvl2pPr marL="742950" indent="-28575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2pPr>
              <a:lvl3pPr marL="11430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3pPr>
              <a:lvl4pPr marL="16002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4pPr>
              <a:lvl5pPr marL="20574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9pPr>
            </a:lstStyle>
            <a:p>
              <a:pPr>
                <a:buFontTx/>
                <a:buNone/>
              </a:pPr>
              <a:r>
                <a:rPr lang="da-DK" sz="2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sz="2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Text Box 13"/>
            <p:cNvSpPr txBox="1">
              <a:spLocks noChangeArrowheads="1"/>
            </p:cNvSpPr>
            <p:nvPr/>
          </p:nvSpPr>
          <p:spPr bwMode="auto">
            <a:xfrm>
              <a:off x="2611688" y="2878752"/>
              <a:ext cx="389845" cy="4255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miter lim="800000"/>
                  <a:headEnd type="none" w="sm" len="sm"/>
                  <a:tailEnd type="none" w="sm" len="sm"/>
                </a14:hiddenLine>
              </a:ext>
            </a:extLst>
          </p:spPr>
          <p:txBody>
            <a:bodyPr lIns="116668" tIns="58334" rIns="116668" bIns="58334">
              <a:spAutoFit/>
            </a:bodyPr>
            <a:lstStyle>
              <a:lvl1pPr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1pPr>
              <a:lvl2pPr marL="742950" indent="-28575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2pPr>
              <a:lvl3pPr marL="11430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3pPr>
              <a:lvl4pPr marL="16002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4pPr>
              <a:lvl5pPr marL="20574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9pPr>
            </a:lstStyle>
            <a:p>
              <a:pPr>
                <a:buFontTx/>
                <a:buNone/>
              </a:pPr>
              <a:r>
                <a:rPr lang="da-DK" sz="2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sz="2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Text Box 13"/>
            <p:cNvSpPr txBox="1">
              <a:spLocks noChangeArrowheads="1"/>
            </p:cNvSpPr>
            <p:nvPr/>
          </p:nvSpPr>
          <p:spPr bwMode="auto">
            <a:xfrm>
              <a:off x="3720963" y="2769891"/>
              <a:ext cx="389845" cy="42558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12700">
                  <a:solidFill>
                    <a:srgbClr val="000000"/>
                  </a:solidFill>
                  <a:miter lim="800000"/>
                  <a:headEnd type="none" w="sm" len="sm"/>
                  <a:tailEnd type="none" w="sm" len="sm"/>
                </a14:hiddenLine>
              </a:ext>
            </a:extLst>
          </p:spPr>
          <p:txBody>
            <a:bodyPr lIns="116668" tIns="58334" rIns="116668" bIns="58334">
              <a:spAutoFit/>
            </a:bodyPr>
            <a:lstStyle>
              <a:lvl1pPr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1pPr>
              <a:lvl2pPr marL="742950" indent="-28575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2pPr>
              <a:lvl3pPr marL="11430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3pPr>
              <a:lvl4pPr marL="16002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4pPr>
              <a:lvl5pPr marL="2057400" indent="-228600"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•"/>
                <a:defRPr sz="3200" b="1">
                  <a:solidFill>
                    <a:srgbClr val="FFFF00"/>
                  </a:solidFill>
                  <a:latin typeface="Arial" pitchFamily="34" charset="0"/>
                  <a:ea typeface="ヒラギノ角ゴ Pro W3"/>
                  <a:cs typeface="ヒラギノ角ゴ Pro W3"/>
                </a:defRPr>
              </a:lvl9pPr>
            </a:lstStyle>
            <a:p>
              <a:pPr>
                <a:buFontTx/>
                <a:buNone/>
              </a:pPr>
              <a:r>
                <a:rPr lang="da-DK" sz="2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sz="2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723206" y="1946427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4800600" y="1946428"/>
              <a:ext cx="3097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a-DK" sz="16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en-GB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354001" y="347246"/>
              <a:ext cx="78899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ig. S3</a:t>
              </a:r>
              <a:endPara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5767679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</a:spPr>
      <a:bodyPr rtlCol="0" anchor="ctr"/>
      <a:lstStyle>
        <a:defPPr algn="ctr">
          <a:defRPr sz="1100" dirty="0" smtClean="0">
            <a:solidFill>
              <a:schemeClr val="tx1"/>
            </a:solidFill>
            <a:latin typeface="Times New Roman" panose="02020603050405020304" pitchFamily="18" charset="0"/>
            <a:cs typeface="Times New Roman" panose="02020603050405020304" pitchFamily="18" charset="0"/>
          </a:defRPr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184</TotalTime>
  <Words>195</Words>
  <Application>Microsoft Office PowerPoint</Application>
  <PresentationFormat>On-screen Show (4:3)</PresentationFormat>
  <Paragraphs>147</Paragraphs>
  <Slides>4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0" baseType="lpstr">
      <vt:lpstr>Arial</vt:lpstr>
      <vt:lpstr>Calibri</vt:lpstr>
      <vt:lpstr>Times New Roman</vt:lpstr>
      <vt:lpstr>Verdana</vt:lpstr>
      <vt:lpstr>ヒラギノ角ゴ Pro W3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imple</dc:creator>
  <cp:lastModifiedBy>Simple Kothari</cp:lastModifiedBy>
  <cp:revision>200</cp:revision>
  <cp:lastPrinted>2016-01-25T12:13:10Z</cp:lastPrinted>
  <dcterms:created xsi:type="dcterms:W3CDTF">2015-06-04T05:15:06Z</dcterms:created>
  <dcterms:modified xsi:type="dcterms:W3CDTF">2016-04-15T20:32:32Z</dcterms:modified>
</cp:coreProperties>
</file>